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19CFF-9095-4DEC-8E85-CE11CCFF7C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64B5A-C8B3-438C-9471-7CEE6133BA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0E36C-2012-489A-8CED-D1C87CD396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7490C-5098-49F2-86A1-FE383A4A9B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256EE-0D18-425A-A3B4-CA3025B437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D553F-6DB8-477B-BA13-698E5ACEBA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2CEB9-E800-4B7A-8040-4208A10A10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31CDB-17CE-4DC2-AF23-77BA5D413B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928DD-DE3B-4179-93F0-6C7B046F09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953BA-168E-4AC0-B401-7C0C6E9FA7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355C7-AD1E-4154-8B28-4282B6120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90705-F6F2-4A7B-9844-8B87A0268D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A82C05-2BFE-4A96-9AD8-F59DCC6CE25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8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3520" y="988920"/>
            <a:ext cx="2590560" cy="1463400"/>
            <a:chOff x="533520" y="988920"/>
            <a:chExt cx="2590560" cy="1463400"/>
          </a:xfrm>
        </p:grpSpPr>
        <p:sp>
          <p:nvSpPr>
            <p:cNvPr id="42" name=""/>
            <p:cNvSpPr/>
            <p:nvPr/>
          </p:nvSpPr>
          <p:spPr>
            <a:xfrm>
              <a:off x="1225440" y="1320840"/>
              <a:ext cx="295560" cy="763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960560" y="1589040"/>
              <a:ext cx="298440" cy="495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700360" y="2004840"/>
              <a:ext cx="293760" cy="79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1373040" y="1219320"/>
              <a:ext cx="1800" cy="101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357200" y="1219320"/>
              <a:ext cx="33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2106720" y="1531440"/>
              <a:ext cx="1440" cy="57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093760" y="1531800"/>
              <a:ext cx="3024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V="1">
              <a:off x="2847960" y="1995480"/>
              <a:ext cx="1440" cy="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833560" y="1995480"/>
              <a:ext cx="32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004760" y="1052640"/>
              <a:ext cx="1800" cy="1031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004760" y="208440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004760" y="1957320"/>
              <a:ext cx="22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004760" y="1825560"/>
              <a:ext cx="22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004760" y="16970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004760" y="157320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004760" y="14461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004760" y="1314360"/>
              <a:ext cx="223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004760" y="118440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004760" y="105264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004760" y="2084400"/>
              <a:ext cx="2119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1004760" y="2052720"/>
              <a:ext cx="180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1739880" y="2052720"/>
              <a:ext cx="144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2481120" y="2052720"/>
              <a:ext cx="180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523880" y="1143000"/>
              <a:ext cx="1171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XopN(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2760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85800" y="2038320"/>
              <a:ext cx="32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E+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86160" y="190656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5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86160" y="177804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0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86160" y="164952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5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86160" y="152712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0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686160" y="139860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5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86160" y="127944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.0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86160" y="113976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.5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86160" y="1011240"/>
              <a:ext cx="30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4.0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336680" y="21826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076480" y="21826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11600" y="21826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902960" y="233028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28800" y="149364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 rot="16200000">
            <a:off x="3000600" y="149364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536360" y="1012680"/>
            <a:ext cx="1014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XopW(</a:t>
            </a: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3356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110120" y="1279440"/>
            <a:ext cx="306360" cy="858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876920" y="1371600"/>
            <a:ext cx="304560" cy="766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641920" y="1677960"/>
            <a:ext cx="306360" cy="460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4260960" y="1044720"/>
            <a:ext cx="0" cy="23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46560" y="104472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5025960" y="1319040"/>
            <a:ext cx="0" cy="5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013360" y="131904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5792760" y="1456920"/>
            <a:ext cx="0" cy="220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778360" y="1457280"/>
            <a:ext cx="3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879720" y="973080"/>
            <a:ext cx="0" cy="1165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879720" y="213840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879720" y="190800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879720" y="16700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879720" y="14414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879720" y="120348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879720" y="97308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879720" y="2138400"/>
            <a:ext cx="2297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3879720" y="2098800"/>
            <a:ext cx="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4646520" y="2098800"/>
            <a:ext cx="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5411880" y="2098800"/>
            <a:ext cx="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636000" y="20811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636000" y="18525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636000" y="16178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636000" y="13874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636000" y="115092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636000" y="9208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765320" y="233856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619760" y="228600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6200000">
            <a:off x="5913720" y="146808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654960" y="1271520"/>
            <a:ext cx="2199960" cy="798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934320" y="1523880"/>
            <a:ext cx="296640" cy="536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7667640" y="1628640"/>
            <a:ext cx="293760" cy="432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400960" y="2014560"/>
            <a:ext cx="297000" cy="46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7085160" y="1452600"/>
            <a:ext cx="0" cy="71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068960" y="1452600"/>
            <a:ext cx="302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7812000" y="1596960"/>
            <a:ext cx="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7799400" y="1596960"/>
            <a:ext cx="302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V="1">
            <a:off x="8547120" y="2009520"/>
            <a:ext cx="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8534520" y="2009880"/>
            <a:ext cx="298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716880" y="1266840"/>
            <a:ext cx="0" cy="793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716880" y="206064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716880" y="190332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716880" y="174456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716880" y="158256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716880" y="142416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716880" y="1266840"/>
            <a:ext cx="18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716880" y="2060640"/>
            <a:ext cx="210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6716880" y="2036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V="1">
            <a:off x="7450200" y="2036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8180280" y="2036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8812080" y="203688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570720" y="20066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6559560" y="18684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559560" y="17082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559560" y="1544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6559560" y="1386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6559560" y="1228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7047000" y="213660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7783560" y="213660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8515440" y="21366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7313400" y="990720"/>
            <a:ext cx="956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F(</a:t>
            </a: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3417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117440" y="3156120"/>
            <a:ext cx="284400" cy="541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828800" y="3200400"/>
            <a:ext cx="285840" cy="496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541600" y="3306600"/>
            <a:ext cx="284040" cy="3906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1258920" y="2991960"/>
            <a:ext cx="0" cy="163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244520" y="299232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V="1">
            <a:off x="1971720" y="3130560"/>
            <a:ext cx="0" cy="69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955880" y="313056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2682720" y="3149640"/>
            <a:ext cx="0" cy="156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670120" y="314964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903240" y="2905200"/>
            <a:ext cx="0" cy="792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903240" y="36972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903240" y="350028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903240" y="330048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903240" y="310356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903240" y="29052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903240" y="3697200"/>
            <a:ext cx="2057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903240" y="366984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1616040" y="366984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2327400" y="366984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flipV="1">
            <a:off x="2960640" y="366984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92640" y="36464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692640" y="34624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686520" y="326700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692640" y="306720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692640" y="28684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230480" y="37702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938240" y="37702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649600" y="37702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775880" y="394812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rot="16200000">
            <a:off x="25560" y="314316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546200" y="2889360"/>
            <a:ext cx="141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B2(</a:t>
            </a: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340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202280" y="3235320"/>
            <a:ext cx="272880" cy="461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886280" y="3235320"/>
            <a:ext cx="277920" cy="461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5573880" y="3556080"/>
            <a:ext cx="274320" cy="141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4336920" y="3071880"/>
            <a:ext cx="0" cy="16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324320" y="307188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5022720" y="3089160"/>
            <a:ext cx="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010120" y="308916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5711760" y="3494160"/>
            <a:ext cx="0" cy="61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699160" y="349416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3995640" y="2981160"/>
            <a:ext cx="0" cy="716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3995640" y="36972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995640" y="358128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995640" y="34560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3995640" y="334008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995640" y="322092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995640" y="310032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3995640" y="298116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995640" y="3697200"/>
            <a:ext cx="1974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3995640" y="367200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4680000" y="367200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5369040" y="367200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V="1">
            <a:off x="5970600" y="367524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4670640" y="2897280"/>
            <a:ext cx="974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G(PXO_0195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841920" y="36529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3836880" y="3541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836880" y="34196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3830760" y="33116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827520" y="31957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822840" y="30718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822840" y="29401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303800" y="37609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992840" y="37609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5675400" y="37609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874760" y="384984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rot="16200000">
            <a:off x="3170520" y="314928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rot="16200000">
            <a:off x="5889600" y="309852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7307640" y="2779560"/>
            <a:ext cx="1142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X(PXO_01953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6918480" y="2990880"/>
            <a:ext cx="280800" cy="689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7620120" y="3124080"/>
            <a:ext cx="280800" cy="555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8323200" y="3513240"/>
            <a:ext cx="281160" cy="166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7058160" y="2905200"/>
            <a:ext cx="0" cy="85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7043760" y="29052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V="1">
            <a:off x="7759800" y="3100320"/>
            <a:ext cx="0" cy="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7745400" y="310032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flipV="1">
            <a:off x="8461440" y="3497400"/>
            <a:ext cx="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8450280" y="349740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710400" y="2838600"/>
            <a:ext cx="0" cy="841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6710400" y="367992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6710400" y="355752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6710400" y="34416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6710400" y="331956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6710400" y="32004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6710400" y="30798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6710400" y="296244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6710400" y="28386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6710400" y="3679920"/>
            <a:ext cx="2104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 flipV="1">
            <a:off x="6710400" y="36525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V="1">
            <a:off x="7412040" y="36525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flipV="1">
            <a:off x="8113680" y="36525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 flipV="1">
            <a:off x="8815320" y="36525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6558120" y="36399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6558120" y="35226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6558120" y="34034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6558120" y="32781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6558120" y="31669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6558120" y="30416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6558120" y="29242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6558120" y="27972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7023240" y="37591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7729560" y="37591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8429760" y="37591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7536960" y="389088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128600" y="4805280"/>
            <a:ext cx="314280" cy="730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905120" y="4876920"/>
            <a:ext cx="311040" cy="65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678040" y="5234040"/>
            <a:ext cx="314280" cy="301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896760" y="4740120"/>
            <a:ext cx="0" cy="795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896760" y="553572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896760" y="542304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896760" y="530856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896760" y="519588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896760" y="507852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896760" y="496584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896760" y="485316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896760" y="4740120"/>
            <a:ext cx="24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896760" y="5535720"/>
            <a:ext cx="2327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V="1">
            <a:off x="896760" y="55119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flipV="1">
            <a:off x="1674720" y="55119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V="1">
            <a:off x="2446200" y="55119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V="1">
            <a:off x="3224160" y="55119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446480" y="4572000"/>
            <a:ext cx="1006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D6(PXO-0341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634320" y="54928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634320" y="538020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634320" y="526716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634320" y="51544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634320" y="50356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634320" y="492300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634320" y="480996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34320" y="46972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1241280" y="56055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017800" y="56055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795760" y="56055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rot="16200000">
            <a:off x="-24840" y="498456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599840" y="579132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238640" y="5018040"/>
            <a:ext cx="290520" cy="507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4952880" y="4952880"/>
            <a:ext cx="287280" cy="573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5664240" y="5265720"/>
            <a:ext cx="290520" cy="260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025880" y="4792680"/>
            <a:ext cx="0" cy="733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025880" y="55260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4025880" y="534348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025880" y="516096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4025880" y="49752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4025880" y="479268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025880" y="5526000"/>
            <a:ext cx="2141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 flipV="1">
            <a:off x="4025880" y="5503680"/>
            <a:ext cx="0" cy="21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flipV="1">
            <a:off x="4741920" y="5503680"/>
            <a:ext cx="0" cy="21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flipV="1">
            <a:off x="5452920" y="5503680"/>
            <a:ext cx="0" cy="21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V="1">
            <a:off x="6167520" y="5503680"/>
            <a:ext cx="0" cy="21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646880" y="4572000"/>
            <a:ext cx="1006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HrpD5(PXO-0340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3783960" y="54864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3783960" y="530388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783960" y="51228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783960" y="49356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783960" y="475308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341960" y="55911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5057640" y="55911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5773680" y="55911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rot="16200000">
            <a:off x="3076560" y="507492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1" name=""/>
          <p:cNvGrpSpPr/>
          <p:nvPr/>
        </p:nvGrpSpPr>
        <p:grpSpPr>
          <a:xfrm>
            <a:off x="6477120" y="4648320"/>
            <a:ext cx="2376360" cy="997560"/>
            <a:chOff x="6477120" y="4648320"/>
            <a:chExt cx="2376360" cy="997560"/>
          </a:xfrm>
        </p:grpSpPr>
        <p:sp>
          <p:nvSpPr>
            <p:cNvPr id="302" name=""/>
            <p:cNvSpPr/>
            <p:nvPr/>
          </p:nvSpPr>
          <p:spPr>
            <a:xfrm>
              <a:off x="7034040" y="4843440"/>
              <a:ext cx="274680" cy="633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7709040" y="5129280"/>
              <a:ext cx="269640" cy="347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8380440" y="5195880"/>
              <a:ext cx="272880" cy="281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6834240" y="4786200"/>
              <a:ext cx="0" cy="690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6834240" y="54770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6834240" y="53625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6834240" y="52484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6834240" y="51292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6834240" y="50148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6834240" y="49006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6834240" y="47862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6834240" y="5477040"/>
              <a:ext cx="2019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flipV="1">
              <a:off x="6834240" y="545616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flipV="1">
              <a:off x="7508880" y="545616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flipV="1">
              <a:off x="8178840" y="545616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flipV="1">
              <a:off x="8853480" y="545616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7466040" y="4648320"/>
              <a:ext cx="936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cC(PXO-03393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6606360" y="544032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6606360" y="532620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6606360" y="521172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6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6606360" y="509256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6606360" y="497844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6606360" y="486396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7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6606360" y="474984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0.0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7132320" y="553896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7806960" y="553896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8481600" y="5538960"/>
              <a:ext cx="113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rot="16200000">
              <a:off x="6043320" y="5084640"/>
              <a:ext cx="974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0" name=""/>
          <p:cNvSpPr/>
          <p:nvPr/>
        </p:nvSpPr>
        <p:spPr>
          <a:xfrm>
            <a:off x="4876560" y="579132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7848360" y="5715000"/>
            <a:ext cx="26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2" name=""/>
          <p:cNvGrpSpPr/>
          <p:nvPr/>
        </p:nvGrpSpPr>
        <p:grpSpPr>
          <a:xfrm>
            <a:off x="304920" y="685800"/>
            <a:ext cx="8462880" cy="5398920"/>
            <a:chOff x="304920" y="685800"/>
            <a:chExt cx="8462880" cy="5398920"/>
          </a:xfrm>
        </p:grpSpPr>
        <p:sp>
          <p:nvSpPr>
            <p:cNvPr id="333" name=""/>
            <p:cNvSpPr/>
            <p:nvPr/>
          </p:nvSpPr>
          <p:spPr>
            <a:xfrm>
              <a:off x="1108080" y="876240"/>
              <a:ext cx="301680" cy="992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855800" y="1434960"/>
              <a:ext cx="297000" cy="433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2598840" y="914400"/>
              <a:ext cx="299880" cy="954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887400" y="814320"/>
              <a:ext cx="0" cy="1054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887400" y="186840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887400" y="169560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887400" y="15159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887400" y="13413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887400" y="11685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887400" y="9889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887400" y="8143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887400" y="1868400"/>
              <a:ext cx="2238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88740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163512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V="1">
              <a:off x="237816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312588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446480" y="685800"/>
              <a:ext cx="936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A(PXO-01578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459000" y="175248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59000" y="160020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459000" y="144792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59000" y="129528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59000" y="114300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59000" y="99072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59000" y="838080"/>
              <a:ext cx="36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1216080" y="19620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963800" y="19620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2711520" y="19620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 rot="16200000">
              <a:off x="-199440" y="126504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7453080" y="596268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605040" y="4896000"/>
              <a:ext cx="2136960" cy="826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819600" y="5683320"/>
              <a:ext cx="282600" cy="39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530600" y="5570640"/>
              <a:ext cx="284400" cy="152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5243400" y="5178600"/>
              <a:ext cx="284400" cy="544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flipV="1">
              <a:off x="3959280" y="5640120"/>
              <a:ext cx="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946680" y="5640480"/>
              <a:ext cx="2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V="1">
              <a:off x="4670280" y="5514480"/>
              <a:ext cx="0" cy="5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4657680" y="5514840"/>
              <a:ext cx="30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flipV="1">
              <a:off x="5383080" y="494964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5370480" y="4950000"/>
              <a:ext cx="3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3605040" y="4896000"/>
              <a:ext cx="0" cy="826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605040" y="57229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3605040" y="56023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605040" y="54878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605040" y="53690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605040" y="52484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605040" y="512928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605040" y="501480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605040" y="489600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3605040" y="5722920"/>
              <a:ext cx="2136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flipV="1">
              <a:off x="3605040" y="56941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V="1">
              <a:off x="4317840" y="56941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flipV="1">
              <a:off x="5029200" y="56941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flipV="1">
              <a:off x="5742000" y="56941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4065120" y="4834080"/>
              <a:ext cx="1020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Che A(PXO_00032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3440160" y="56847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3440160" y="55627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3433680" y="54500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433680" y="53308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3440160" y="52117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3433680" y="50911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3433680" y="49766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3433680" y="48560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929040" y="579744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4640400" y="579744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5353200" y="57974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 flipH="1" flipV="1">
              <a:off x="3276000" y="4647600"/>
              <a:ext cx="122040" cy="1150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568400" y="595296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6686640" y="5705640"/>
              <a:ext cx="307800" cy="58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7458120" y="5689440"/>
              <a:ext cx="304920" cy="74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8226360" y="5219640"/>
              <a:ext cx="308160" cy="54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 flipV="1">
              <a:off x="6837480" y="5689080"/>
              <a:ext cx="0" cy="1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6823080" y="5689440"/>
              <a:ext cx="3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 flipV="1">
              <a:off x="7608960" y="5667120"/>
              <a:ext cx="0" cy="2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7594560" y="5667480"/>
              <a:ext cx="3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 flipV="1">
              <a:off x="8377200" y="5046840"/>
              <a:ext cx="0" cy="172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8362800" y="5046840"/>
              <a:ext cx="3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6456240" y="4943520"/>
              <a:ext cx="0" cy="82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6456240" y="57643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6456240" y="566100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6456240" y="555948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6456240" y="545796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6456240" y="53546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6456240" y="52513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6456240" y="514980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6456240" y="504684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6456240" y="4943520"/>
              <a:ext cx="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6456240" y="5764320"/>
              <a:ext cx="2308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 flipV="1">
              <a:off x="6456240" y="573840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 flipV="1">
              <a:off x="7224840" y="573840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 flipV="1">
              <a:off x="7996320" y="573840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 flipV="1">
              <a:off x="8764560" y="573840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6879960" y="4819680"/>
              <a:ext cx="1026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Che D(PXO_00056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6281640" y="57261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6281640" y="56246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6281640" y="55227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6281640" y="54198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6281640" y="53164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6281640" y="52135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6281640" y="51116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6281640" y="50068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6281640" y="49053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6823080" y="58402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7594560" y="58402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8362800" y="58402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 rot="16200000">
              <a:off x="5646960" y="520524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3867120" y="1006560"/>
              <a:ext cx="333360" cy="861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4694400" y="1174680"/>
              <a:ext cx="328320" cy="693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5514840" y="1657440"/>
              <a:ext cx="333360" cy="210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3621240" y="820800"/>
              <a:ext cx="0" cy="1047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3621240" y="186840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3621240" y="17193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3621240" y="15717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3621240" y="14223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3621240" y="12668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3621240" y="11192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3621240" y="9698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3621240" y="82080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3621240" y="1868400"/>
              <a:ext cx="2473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 flipV="1">
              <a:off x="362124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 flipV="1">
              <a:off x="444672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 flipV="1">
              <a:off x="526896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flipV="1">
              <a:off x="6094440" y="183816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4265640" y="762120"/>
              <a:ext cx="1000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A1(PXO-03392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3436920" y="18129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3436920" y="16635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3436920" y="15159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3436920" y="1366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3436920" y="12114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3436920" y="10638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3436920" y="9144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3436920" y="7650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3987720" y="19620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4815000" y="19620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5640480" y="19620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 rot="16200000">
              <a:off x="2797200" y="124452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6694560" y="1447920"/>
              <a:ext cx="306360" cy="38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7459560" y="1544760"/>
              <a:ext cx="311400" cy="288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8229600" y="1332000"/>
              <a:ext cx="306360" cy="501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 flipV="1">
              <a:off x="6845400" y="1312560"/>
              <a:ext cx="0" cy="135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6831000" y="131292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 flipV="1">
              <a:off x="7615080" y="1472760"/>
              <a:ext cx="0" cy="716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7601040" y="147312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 flipV="1">
              <a:off x="8380440" y="966960"/>
              <a:ext cx="0" cy="3650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8367840" y="96696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6464160" y="830160"/>
              <a:ext cx="0" cy="100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6464160" y="183348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6464160" y="163512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6464160" y="143496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6464160" y="123048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6464160" y="103032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6464160" y="830160"/>
              <a:ext cx="24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6464160" y="1833480"/>
              <a:ext cx="2301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 flipV="1">
              <a:off x="6464160" y="18018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 flipV="1">
              <a:off x="7229520" y="18018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 flipV="1">
              <a:off x="8001000" y="18018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 flipV="1">
              <a:off x="8766000" y="18018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7084800" y="762120"/>
              <a:ext cx="988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pA2(PXO_0339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6248880" y="1776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6248880" y="1576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6248880" y="1378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6248880" y="1171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6248880" y="973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6248880" y="773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6808680" y="193032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7574040" y="193032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8339040" y="19303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 rot="16200000">
              <a:off x="5618160" y="125712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1754280" y="205740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4573440" y="205740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7469280" y="205740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1085760" y="3348000"/>
              <a:ext cx="290520" cy="606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1814400" y="3413160"/>
              <a:ext cx="295560" cy="541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2548080" y="3654360"/>
              <a:ext cx="290520" cy="300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 flipV="1">
              <a:off x="1228680" y="3187440"/>
              <a:ext cx="0" cy="1602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1216080" y="318780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 flipV="1">
              <a:off x="1962000" y="3257640"/>
              <a:ext cx="0" cy="155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1949400" y="325764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 flipV="1">
              <a:off x="2690640" y="3519000"/>
              <a:ext cx="0" cy="135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2678040" y="351936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870120" y="3102120"/>
              <a:ext cx="0" cy="85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870120" y="39546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870120" y="38307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870120" y="37130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870120" y="35892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870120" y="34671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870120" y="33433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870120" y="32259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870120" y="31021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870120" y="3954600"/>
              <a:ext cx="2189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flipV="1">
              <a:off x="870120" y="39272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flipV="1">
              <a:off x="1596960" y="39272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flipV="1">
              <a:off x="2330280" y="39272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flipV="1">
              <a:off x="3059280" y="39272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1522440" y="2819520"/>
              <a:ext cx="1000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B1(PXO-0340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665640" y="3905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665640" y="3782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665640" y="36655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665640" y="35416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665640" y="3417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665640" y="32958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665640" y="3176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665640" y="3054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1193760" y="40338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1927080" y="40338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2655720" y="40338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 rot="16200000">
              <a:off x="39960" y="336060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3809880" y="3352680"/>
              <a:ext cx="274680" cy="577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489560" y="3390840"/>
              <a:ext cx="271440" cy="530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5168880" y="3503520"/>
              <a:ext cx="274680" cy="417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 flipV="1">
              <a:off x="3943440" y="3161880"/>
              <a:ext cx="0" cy="181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3932280" y="316224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 flipV="1">
              <a:off x="4622760" y="3308040"/>
              <a:ext cx="0" cy="82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4611600" y="330840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 flipV="1">
              <a:off x="5307120" y="3335040"/>
              <a:ext cx="0" cy="1681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5294160" y="3335400"/>
              <a:ext cx="288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3603600" y="3070080"/>
              <a:ext cx="0" cy="851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3603600" y="3921120"/>
              <a:ext cx="17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3603600" y="3711600"/>
              <a:ext cx="17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3603600" y="3495600"/>
              <a:ext cx="17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3603600" y="3286080"/>
              <a:ext cx="17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3603600" y="3070080"/>
              <a:ext cx="17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3603600" y="3921120"/>
              <a:ext cx="2046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 flipV="1">
              <a:off x="3603600" y="38923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 flipV="1">
              <a:off x="4287960" y="38923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 flipV="1">
              <a:off x="4967280" y="38923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 flipV="1">
              <a:off x="5649840" y="389232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4265640" y="2819520"/>
              <a:ext cx="1000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B2(PXO-03400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3353400" y="3809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3353400" y="36576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3353400" y="3429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3353400" y="3200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3353400" y="3048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3914640" y="40035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4599000" y="40035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5281560" y="40035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 rot="16200000">
              <a:off x="2695680" y="339876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6597720" y="3454560"/>
              <a:ext cx="322200" cy="474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7400880" y="3670200"/>
              <a:ext cx="322200" cy="258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8204040" y="3757680"/>
              <a:ext cx="322560" cy="171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 flipV="1">
              <a:off x="6756480" y="3250800"/>
              <a:ext cx="0" cy="2034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6742080" y="3251160"/>
              <a:ext cx="334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 flipV="1">
              <a:off x="7559640" y="3596760"/>
              <a:ext cx="0" cy="73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7545240" y="3597120"/>
              <a:ext cx="334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 flipV="1">
              <a:off x="8362800" y="3676320"/>
              <a:ext cx="0" cy="81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8348760" y="367668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6357960" y="3170160"/>
              <a:ext cx="0" cy="75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6357960" y="392904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6357960" y="377496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6357960" y="362736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6357960" y="347328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6357960" y="332568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6357960" y="317016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6357960" y="3929040"/>
              <a:ext cx="2409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 flipV="1">
              <a:off x="6357960" y="39052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 flipV="1">
              <a:off x="7161120" y="39052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 flipV="1">
              <a:off x="7964640" y="39052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 flipV="1">
              <a:off x="8767800" y="39052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7084800" y="2895480"/>
              <a:ext cx="1000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B4(PXO-03398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6020640" y="38862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6020640" y="37339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6020640" y="358128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6020640" y="34290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6020640" y="32767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6020640" y="312408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6727680" y="40035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7531200" y="40035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8334360" y="40035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 rot="16200000">
              <a:off x="5362560" y="339876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1077840" y="5045040"/>
              <a:ext cx="312840" cy="657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1857240" y="5124600"/>
              <a:ext cx="317520" cy="577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2641680" y="5532480"/>
              <a:ext cx="312480" cy="169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844560" y="4965840"/>
              <a:ext cx="0" cy="736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844560" y="570240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844560" y="559584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844560" y="549108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844560" y="538488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844560" y="528336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844560" y="517860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844560" y="507204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844560" y="496584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844560" y="5702400"/>
              <a:ext cx="2343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 flipV="1">
              <a:off x="844560" y="56815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 flipV="1">
              <a:off x="1623960" y="56815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 flipV="1">
              <a:off x="2408400" y="56815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 flipV="1">
              <a:off x="3187800" y="56815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1401840" y="4797360"/>
              <a:ext cx="962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HrpE(PXO_0341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611640" y="5661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611640" y="5553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611640" y="5445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611640" y="5337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611640" y="5229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611640" y="5121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610200" y="5029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611640" y="4905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1203480" y="57657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1984320" y="57657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2763720" y="57657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 rot="16200000">
              <a:off x="-47160" y="515124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1763280" y="422100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4463640" y="418464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7451280" y="418464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1834920" y="595008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5" name=""/>
          <p:cNvGrpSpPr/>
          <p:nvPr/>
        </p:nvGrpSpPr>
        <p:grpSpPr>
          <a:xfrm>
            <a:off x="460440" y="876960"/>
            <a:ext cx="8420040" cy="5230080"/>
            <a:chOff x="460440" y="876960"/>
            <a:chExt cx="8420040" cy="5230080"/>
          </a:xfrm>
        </p:grpSpPr>
        <p:grpSp>
          <p:nvGrpSpPr>
            <p:cNvPr id="636" name=""/>
            <p:cNvGrpSpPr/>
            <p:nvPr/>
          </p:nvGrpSpPr>
          <p:grpSpPr>
            <a:xfrm>
              <a:off x="531720" y="876960"/>
              <a:ext cx="5278680" cy="1518480"/>
              <a:chOff x="531720" y="876960"/>
              <a:chExt cx="5278680" cy="1518480"/>
            </a:xfrm>
          </p:grpSpPr>
          <p:sp>
            <p:nvSpPr>
              <p:cNvPr id="637" name=""/>
              <p:cNvSpPr/>
              <p:nvPr/>
            </p:nvSpPr>
            <p:spPr>
              <a:xfrm>
                <a:off x="812880" y="1087560"/>
                <a:ext cx="2347920" cy="958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1052640" y="2008080"/>
                <a:ext cx="320400" cy="381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1857240" y="1976400"/>
                <a:ext cx="327240" cy="698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2666880" y="1447920"/>
                <a:ext cx="322560" cy="598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 flipV="1">
                <a:off x="1211400" y="1995120"/>
                <a:ext cx="0" cy="1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1195560" y="1995480"/>
                <a:ext cx="3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 flipV="1">
                <a:off x="2021040" y="1963440"/>
                <a:ext cx="0" cy="1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2006640" y="1963800"/>
                <a:ext cx="33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 flipV="1">
                <a:off x="2825640" y="1170000"/>
                <a:ext cx="0" cy="27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2811600" y="1170000"/>
                <a:ext cx="33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812880" y="1087560"/>
                <a:ext cx="0" cy="958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812880" y="20462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812880" y="1906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812880" y="17748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812880" y="1636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812880" y="1498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812880" y="1359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812880" y="12272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812880" y="1087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812880" y="2046240"/>
                <a:ext cx="234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 flipV="1">
                <a:off x="812880" y="20145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 flipV="1">
                <a:off x="1619280" y="20145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 flipV="1">
                <a:off x="2427120" y="20145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 flipV="1">
                <a:off x="3164040" y="20145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1406520" y="1165320"/>
                <a:ext cx="1006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900" spc="-1" strike="noStrike">
                    <a:solidFill>
                      <a:srgbClr val="000000"/>
                    </a:solidFill>
                    <a:latin typeface="Arial"/>
                  </a:rPr>
                  <a:t>Mot C(PXO_00026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641520" y="19843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639720" y="18622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639720" y="17319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639720" y="1593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639720" y="14540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641520" y="13161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639720" y="1184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639720" y="10429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1176480" y="2135160"/>
                <a:ext cx="12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1987560" y="2135160"/>
                <a:ext cx="12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2793960" y="213516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1810800" y="2273400"/>
                <a:ext cx="267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Stra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 rot="16200000">
                <a:off x="27000" y="1447560"/>
                <a:ext cx="1131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Relative expression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3905280" y="1898640"/>
                <a:ext cx="279360" cy="81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4611600" y="1879560"/>
                <a:ext cx="279360" cy="1000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5318280" y="1370160"/>
                <a:ext cx="279360" cy="609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 flipV="1">
                <a:off x="4043520" y="187920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4030560" y="1879560"/>
                <a:ext cx="3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 flipV="1">
                <a:off x="4749840" y="1866600"/>
                <a:ext cx="0" cy="1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4737240" y="186696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 flipV="1">
                <a:off x="5454720" y="1093680"/>
                <a:ext cx="0" cy="276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5442120" y="1093680"/>
                <a:ext cx="29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3692520" y="1023840"/>
                <a:ext cx="0" cy="955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3692520" y="197964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3692520" y="182088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3692520" y="165888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3692520" y="150336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3692520" y="134604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3692520" y="118260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3692520" y="1023840"/>
                <a:ext cx="20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3692520" y="1979640"/>
                <a:ext cx="211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 flipV="1">
                <a:off x="3692520" y="19479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 flipV="1">
                <a:off x="4397400" y="19479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 flipV="1">
                <a:off x="5103720" y="19479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 flipV="1">
                <a:off x="5810400" y="1947960"/>
                <a:ext cx="0" cy="31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4148280" y="1125360"/>
                <a:ext cx="1006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900" spc="-1" strike="noStrike">
                    <a:solidFill>
                      <a:srgbClr val="000000"/>
                    </a:solidFill>
                    <a:latin typeface="Arial"/>
                  </a:rPr>
                  <a:t>Mot D(PXO_00027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3467520" y="1936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3467520" y="1778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3467520" y="1616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3467520" y="14572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3467520" y="13003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3467520" y="1136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3467520" y="9810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4013280" y="2068560"/>
                <a:ext cx="12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4718160" y="2068560"/>
                <a:ext cx="12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5424480" y="206856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4557240" y="2206800"/>
                <a:ext cx="267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Stra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 rot="16200000">
                <a:off x="2824200" y="1381680"/>
                <a:ext cx="1131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Relative expression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0" name=""/>
            <p:cNvSpPr/>
            <p:nvPr/>
          </p:nvSpPr>
          <p:spPr>
            <a:xfrm>
              <a:off x="6621480" y="1967040"/>
              <a:ext cx="325440" cy="19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7427880" y="1954080"/>
              <a:ext cx="320760" cy="32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8229600" y="1600200"/>
              <a:ext cx="325440" cy="38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 flipV="1">
              <a:off x="6781680" y="1956960"/>
              <a:ext cx="0" cy="97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6767640" y="195732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 flipV="1">
              <a:off x="7588080" y="1949040"/>
              <a:ext cx="0" cy="4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7574040" y="194940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 flipV="1">
              <a:off x="8389800" y="1467000"/>
              <a:ext cx="0" cy="1332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"/>
            <p:cNvSpPr/>
            <p:nvPr/>
          </p:nvSpPr>
          <p:spPr>
            <a:xfrm>
              <a:off x="8375760" y="146700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"/>
            <p:cNvSpPr/>
            <p:nvPr/>
          </p:nvSpPr>
          <p:spPr>
            <a:xfrm>
              <a:off x="6380280" y="1378080"/>
              <a:ext cx="0" cy="60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"/>
            <p:cNvSpPr/>
            <p:nvPr/>
          </p:nvSpPr>
          <p:spPr>
            <a:xfrm>
              <a:off x="6380280" y="19861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6380280" y="188748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"/>
            <p:cNvSpPr/>
            <p:nvPr/>
          </p:nvSpPr>
          <p:spPr>
            <a:xfrm>
              <a:off x="6380280" y="17845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>
              <a:off x="6380280" y="16844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"/>
            <p:cNvSpPr/>
            <p:nvPr/>
          </p:nvSpPr>
          <p:spPr>
            <a:xfrm>
              <a:off x="6380280" y="15811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"/>
            <p:cNvSpPr/>
            <p:nvPr/>
          </p:nvSpPr>
          <p:spPr>
            <a:xfrm>
              <a:off x="6380280" y="14810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"/>
            <p:cNvSpPr/>
            <p:nvPr/>
          </p:nvSpPr>
          <p:spPr>
            <a:xfrm>
              <a:off x="6380280" y="137808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6380280" y="1986120"/>
              <a:ext cx="2414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 flipV="1">
              <a:off x="6380280" y="1961640"/>
              <a:ext cx="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"/>
            <p:cNvSpPr/>
            <p:nvPr/>
          </p:nvSpPr>
          <p:spPr>
            <a:xfrm flipV="1">
              <a:off x="7186680" y="1961640"/>
              <a:ext cx="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"/>
            <p:cNvSpPr/>
            <p:nvPr/>
          </p:nvSpPr>
          <p:spPr>
            <a:xfrm flipV="1">
              <a:off x="7988400" y="1961640"/>
              <a:ext cx="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"/>
            <p:cNvSpPr/>
            <p:nvPr/>
          </p:nvSpPr>
          <p:spPr>
            <a:xfrm flipV="1">
              <a:off x="8794800" y="1961640"/>
              <a:ext cx="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"/>
            <p:cNvSpPr/>
            <p:nvPr/>
          </p:nvSpPr>
          <p:spPr>
            <a:xfrm>
              <a:off x="6959520" y="120024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6159960" y="1944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6159960" y="1844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6159960" y="17413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6159960" y="16416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6159960" y="1538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6159960" y="1440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6159960" y="1335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"/>
            <p:cNvSpPr/>
            <p:nvPr/>
          </p:nvSpPr>
          <p:spPr>
            <a:xfrm>
              <a:off x="6738840" y="20574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7545240" y="20574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"/>
            <p:cNvSpPr/>
            <p:nvPr/>
          </p:nvSpPr>
          <p:spPr>
            <a:xfrm>
              <a:off x="8352000" y="20574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 rot="16200000">
              <a:off x="5523120" y="145548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"/>
            <p:cNvSpPr/>
            <p:nvPr/>
          </p:nvSpPr>
          <p:spPr>
            <a:xfrm>
              <a:off x="1063800" y="3618000"/>
              <a:ext cx="288720" cy="30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1774800" y="3511440"/>
              <a:ext cx="285840" cy="136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"/>
            <p:cNvSpPr/>
            <p:nvPr/>
          </p:nvSpPr>
          <p:spPr>
            <a:xfrm>
              <a:off x="2484360" y="3357720"/>
              <a:ext cx="289080" cy="290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"/>
            <p:cNvSpPr/>
            <p:nvPr/>
          </p:nvSpPr>
          <p:spPr>
            <a:xfrm flipV="1">
              <a:off x="1204920" y="3589200"/>
              <a:ext cx="0" cy="28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"/>
            <p:cNvSpPr/>
            <p:nvPr/>
          </p:nvSpPr>
          <p:spPr>
            <a:xfrm>
              <a:off x="1192320" y="3589200"/>
              <a:ext cx="298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"/>
            <p:cNvSpPr/>
            <p:nvPr/>
          </p:nvSpPr>
          <p:spPr>
            <a:xfrm flipV="1">
              <a:off x="1917720" y="3458880"/>
              <a:ext cx="0" cy="522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"/>
            <p:cNvSpPr/>
            <p:nvPr/>
          </p:nvSpPr>
          <p:spPr>
            <a:xfrm>
              <a:off x="1905120" y="3459240"/>
              <a:ext cx="298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"/>
            <p:cNvSpPr/>
            <p:nvPr/>
          </p:nvSpPr>
          <p:spPr>
            <a:xfrm flipV="1">
              <a:off x="2625840" y="3197160"/>
              <a:ext cx="0" cy="1605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"/>
            <p:cNvSpPr/>
            <p:nvPr/>
          </p:nvSpPr>
          <p:spPr>
            <a:xfrm>
              <a:off x="2612880" y="319716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853920" y="3100320"/>
              <a:ext cx="0" cy="54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"/>
            <p:cNvSpPr/>
            <p:nvPr/>
          </p:nvSpPr>
          <p:spPr>
            <a:xfrm>
              <a:off x="853920" y="364824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853920" y="351144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"/>
            <p:cNvSpPr/>
            <p:nvPr/>
          </p:nvSpPr>
          <p:spPr>
            <a:xfrm>
              <a:off x="853920" y="337644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853920" y="323532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853920" y="310032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853920" y="3648240"/>
              <a:ext cx="2132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"/>
            <p:cNvSpPr/>
            <p:nvPr/>
          </p:nvSpPr>
          <p:spPr>
            <a:xfrm flipV="1">
              <a:off x="853920" y="362232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"/>
            <p:cNvSpPr/>
            <p:nvPr/>
          </p:nvSpPr>
          <p:spPr>
            <a:xfrm flipV="1">
              <a:off x="1565280" y="362232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"/>
            <p:cNvSpPr/>
            <p:nvPr/>
          </p:nvSpPr>
          <p:spPr>
            <a:xfrm flipV="1">
              <a:off x="2274840" y="362232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"/>
            <p:cNvSpPr/>
            <p:nvPr/>
          </p:nvSpPr>
          <p:spPr>
            <a:xfrm flipV="1">
              <a:off x="2986200" y="362232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1511280" y="301608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613440" y="3592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613440" y="3484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613440" y="3340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"/>
            <p:cNvSpPr/>
            <p:nvPr/>
          </p:nvSpPr>
          <p:spPr>
            <a:xfrm>
              <a:off x="613440" y="3195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613440" y="3051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1176480" y="371484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1889280" y="371484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2597040" y="37148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 rot="16200000">
              <a:off x="-34560" y="315900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3870360" y="3662280"/>
              <a:ext cx="28404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4584600" y="3649680"/>
              <a:ext cx="289080" cy="38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5303880" y="3349800"/>
              <a:ext cx="284040" cy="338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"/>
            <p:cNvSpPr/>
            <p:nvPr/>
          </p:nvSpPr>
          <p:spPr>
            <a:xfrm flipV="1">
              <a:off x="4013280" y="3655800"/>
              <a:ext cx="0" cy="61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3998880" y="365616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 flipV="1">
              <a:off x="4727520" y="3643200"/>
              <a:ext cx="0" cy="64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4713120" y="364320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 flipV="1">
              <a:off x="5445000" y="3241800"/>
              <a:ext cx="0" cy="108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5432400" y="324180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3656160" y="3051000"/>
              <a:ext cx="0" cy="636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3656160" y="36878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3656160" y="34783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3656160" y="32608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"/>
            <p:cNvSpPr/>
            <p:nvPr/>
          </p:nvSpPr>
          <p:spPr>
            <a:xfrm>
              <a:off x="3656160" y="30510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"/>
            <p:cNvSpPr/>
            <p:nvPr/>
          </p:nvSpPr>
          <p:spPr>
            <a:xfrm>
              <a:off x="3656160" y="3687840"/>
              <a:ext cx="2146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"/>
            <p:cNvSpPr/>
            <p:nvPr/>
          </p:nvSpPr>
          <p:spPr>
            <a:xfrm flipV="1">
              <a:off x="3656160" y="3656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 flipV="1">
              <a:off x="4370400" y="3656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"/>
            <p:cNvSpPr/>
            <p:nvPr/>
          </p:nvSpPr>
          <p:spPr>
            <a:xfrm flipV="1">
              <a:off x="5087880" y="3656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"/>
            <p:cNvSpPr/>
            <p:nvPr/>
          </p:nvSpPr>
          <p:spPr>
            <a:xfrm flipV="1">
              <a:off x="5802480" y="3656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4210200" y="296064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4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3420000" y="3608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3420000" y="3429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3420000" y="3213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3420000" y="2997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3978360" y="37767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4697280" y="377676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5411880" y="37767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 rot="16200000">
              <a:off x="2806920" y="324792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6607080" y="3670200"/>
              <a:ext cx="336600" cy="28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7446960" y="3649680"/>
              <a:ext cx="344520" cy="49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8292960" y="3290760"/>
              <a:ext cx="336600" cy="408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 flipV="1">
              <a:off x="6772320" y="3663720"/>
              <a:ext cx="0" cy="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6750000" y="3664080"/>
              <a:ext cx="50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"/>
            <p:cNvSpPr/>
            <p:nvPr/>
          </p:nvSpPr>
          <p:spPr>
            <a:xfrm flipV="1">
              <a:off x="7618320" y="3641760"/>
              <a:ext cx="0" cy="7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7597800" y="3641760"/>
              <a:ext cx="493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"/>
            <p:cNvSpPr/>
            <p:nvPr/>
          </p:nvSpPr>
          <p:spPr>
            <a:xfrm flipV="1">
              <a:off x="8458200" y="3160440"/>
              <a:ext cx="0" cy="129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8435880" y="3160800"/>
              <a:ext cx="50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6356520" y="3024360"/>
              <a:ext cx="0" cy="67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6356520" y="36990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6356520" y="35845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6356520" y="34765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6356520" y="33624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6356520" y="32479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6356520" y="31399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6356520" y="30243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6356520" y="3699000"/>
              <a:ext cx="2523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"/>
            <p:cNvSpPr/>
            <p:nvPr/>
          </p:nvSpPr>
          <p:spPr>
            <a:xfrm flipV="1">
              <a:off x="6356520" y="36781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"/>
            <p:cNvSpPr/>
            <p:nvPr/>
          </p:nvSpPr>
          <p:spPr>
            <a:xfrm flipV="1">
              <a:off x="7196040" y="36781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"/>
            <p:cNvSpPr/>
            <p:nvPr/>
          </p:nvSpPr>
          <p:spPr>
            <a:xfrm flipV="1">
              <a:off x="8042400" y="36781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"/>
            <p:cNvSpPr/>
            <p:nvPr/>
          </p:nvSpPr>
          <p:spPr>
            <a:xfrm flipV="1">
              <a:off x="8880480" y="367812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7126200" y="292428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6184800" y="36561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6184800" y="35416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6184800" y="34336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6184800" y="33195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6184800" y="32036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6184800" y="30970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6184800" y="29811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6735600" y="37638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7575480" y="37638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8415360" y="37638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"/>
            <p:cNvSpPr/>
            <p:nvPr/>
          </p:nvSpPr>
          <p:spPr>
            <a:xfrm rot="16200000">
              <a:off x="5543640" y="324792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1116000" y="5624640"/>
              <a:ext cx="287280" cy="93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"/>
            <p:cNvSpPr/>
            <p:nvPr/>
          </p:nvSpPr>
          <p:spPr>
            <a:xfrm>
              <a:off x="1838160" y="5524560"/>
              <a:ext cx="287640" cy="193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2560680" y="5265720"/>
              <a:ext cx="285840" cy="452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"/>
            <p:cNvSpPr/>
            <p:nvPr/>
          </p:nvSpPr>
          <p:spPr>
            <a:xfrm flipV="1">
              <a:off x="1260360" y="5594400"/>
              <a:ext cx="0" cy="30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1246320" y="559440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"/>
            <p:cNvSpPr/>
            <p:nvPr/>
          </p:nvSpPr>
          <p:spPr>
            <a:xfrm flipV="1">
              <a:off x="1981080" y="5430960"/>
              <a:ext cx="0" cy="936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1968480" y="543096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"/>
            <p:cNvSpPr/>
            <p:nvPr/>
          </p:nvSpPr>
          <p:spPr>
            <a:xfrm flipV="1">
              <a:off x="2703600" y="5054760"/>
              <a:ext cx="0" cy="2109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2690640" y="5054760"/>
              <a:ext cx="302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"/>
            <p:cNvSpPr/>
            <p:nvPr/>
          </p:nvSpPr>
          <p:spPr>
            <a:xfrm>
              <a:off x="901800" y="4861080"/>
              <a:ext cx="0" cy="857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901800" y="571824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901800" y="554832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901800" y="537696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>
              <a:off x="901800" y="520056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901800" y="503064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901800" y="4861080"/>
              <a:ext cx="27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901800" y="5718240"/>
              <a:ext cx="2165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 flipV="1">
              <a:off x="901800" y="5682960"/>
              <a:ext cx="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 flipV="1">
              <a:off x="1622520" y="5682960"/>
              <a:ext cx="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 flipV="1">
              <a:off x="2344680" y="5682960"/>
              <a:ext cx="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 flipV="1">
              <a:off x="3067200" y="5682960"/>
              <a:ext cx="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1438200" y="479736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600840" y="565308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600840" y="548316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600840" y="53132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600840" y="51372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600840" y="49658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600840" y="47959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1214280" y="581832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1936800" y="581832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2658960" y="58183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 rot="16200000">
              <a:off x="-43920" y="524952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3746520" y="5648400"/>
              <a:ext cx="306360" cy="54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4511520" y="5610240"/>
              <a:ext cx="306720" cy="92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5278320" y="5157720"/>
              <a:ext cx="306360" cy="54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 flipV="1">
              <a:off x="3898800" y="5630400"/>
              <a:ext cx="0" cy="176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3886200" y="563076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 flipV="1">
              <a:off x="4665600" y="5572080"/>
              <a:ext cx="0" cy="38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>
              <a:off x="4651200" y="5572080"/>
              <a:ext cx="320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 flipV="1">
              <a:off x="5430960" y="4932360"/>
              <a:ext cx="0" cy="2253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5418000" y="4932360"/>
              <a:ext cx="320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3516480" y="4871880"/>
              <a:ext cx="0" cy="83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3516480" y="57024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3516480" y="55832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3516480" y="546408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3516480" y="53467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3516480" y="52275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3516480" y="51102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3516480" y="49910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3516480" y="487188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3516480" y="5702400"/>
              <a:ext cx="2298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 flipV="1">
              <a:off x="3516480" y="56750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"/>
            <p:cNvSpPr/>
            <p:nvPr/>
          </p:nvSpPr>
          <p:spPr>
            <a:xfrm flipV="1">
              <a:off x="4282920" y="56750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 flipV="1">
              <a:off x="5048280" y="56750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 flipV="1">
              <a:off x="5815080" y="567504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4195800" y="473868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003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3344760" y="56530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3344760" y="5533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3344760" y="54165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3344760" y="52974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3344760" y="51800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>
              <a:off x="3344760" y="50608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>
              <a:off x="3344760" y="49417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>
              <a:off x="3344760" y="48243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>
              <a:off x="3859200" y="57816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4624560" y="578160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5391000" y="57816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 rot="16200000">
              <a:off x="2716200" y="512280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6558120" y="5697360"/>
              <a:ext cx="3078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"/>
            <p:cNvSpPr/>
            <p:nvPr/>
          </p:nvSpPr>
          <p:spPr>
            <a:xfrm>
              <a:off x="7324560" y="5697360"/>
              <a:ext cx="303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"/>
            <p:cNvSpPr/>
            <p:nvPr/>
          </p:nvSpPr>
          <p:spPr>
            <a:xfrm>
              <a:off x="8085240" y="5362560"/>
              <a:ext cx="307800" cy="341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6710400" y="5697360"/>
              <a:ext cx="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6696000" y="5697360"/>
              <a:ext cx="316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"/>
            <p:cNvSpPr/>
            <p:nvPr/>
          </p:nvSpPr>
          <p:spPr>
            <a:xfrm flipV="1">
              <a:off x="7475400" y="5690880"/>
              <a:ext cx="0" cy="61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7461360" y="5691240"/>
              <a:ext cx="3312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"/>
            <p:cNvSpPr/>
            <p:nvPr/>
          </p:nvSpPr>
          <p:spPr>
            <a:xfrm flipV="1">
              <a:off x="8237520" y="5151600"/>
              <a:ext cx="0" cy="2109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"/>
            <p:cNvSpPr/>
            <p:nvPr/>
          </p:nvSpPr>
          <p:spPr>
            <a:xfrm>
              <a:off x="8223120" y="5151600"/>
              <a:ext cx="320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6329520" y="5003640"/>
              <a:ext cx="0" cy="700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6329520" y="57038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6329520" y="55627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6329520" y="54212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>
              <a:off x="6329520" y="52862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>
              <a:off x="6329520" y="51451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6329520" y="50036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>
              <a:off x="6329520" y="5703840"/>
              <a:ext cx="2293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 flipV="1">
              <a:off x="6329520" y="5672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 flipV="1">
              <a:off x="7094520" y="5672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 flipV="1">
              <a:off x="7856640" y="5672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 flipV="1">
              <a:off x="8623440" y="567216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6983280" y="4797360"/>
              <a:ext cx="625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PXO_0475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>
              <a:off x="6226920" y="5646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6226920" y="5505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6226920" y="5362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6226920" y="5227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>
              <a:off x="6226920" y="5086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6226920" y="4944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>
              <a:off x="6669000" y="58006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7434360" y="5800680"/>
              <a:ext cx="12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>
              <a:off x="8201160" y="58006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C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4568400" y="595296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>
              <a:off x="7380000" y="227664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1726920" y="389736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"/>
            <p:cNvSpPr/>
            <p:nvPr/>
          </p:nvSpPr>
          <p:spPr>
            <a:xfrm>
              <a:off x="7380000" y="393372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"/>
            <p:cNvSpPr/>
            <p:nvPr/>
          </p:nvSpPr>
          <p:spPr>
            <a:xfrm>
              <a:off x="4535280" y="393372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"/>
            <p:cNvSpPr/>
            <p:nvPr/>
          </p:nvSpPr>
          <p:spPr>
            <a:xfrm>
              <a:off x="1763280" y="598500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7308360" y="595008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Str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 rot="16200000">
              <a:off x="5580000" y="5227560"/>
              <a:ext cx="113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</a:rPr>
                <a:t>Relative expression lev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3" name=""/>
          <p:cNvSpPr/>
          <p:nvPr/>
        </p:nvSpPr>
        <p:spPr>
          <a:xfrm>
            <a:off x="681120" y="1257480"/>
            <a:ext cx="2306520" cy="674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"/>
          <p:cNvSpPr/>
          <p:nvPr/>
        </p:nvSpPr>
        <p:spPr>
          <a:xfrm>
            <a:off x="911160" y="1900080"/>
            <a:ext cx="304920" cy="32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"/>
          <p:cNvSpPr/>
          <p:nvPr/>
        </p:nvSpPr>
        <p:spPr>
          <a:xfrm>
            <a:off x="1677960" y="1889280"/>
            <a:ext cx="309600" cy="42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"/>
          <p:cNvSpPr/>
          <p:nvPr/>
        </p:nvSpPr>
        <p:spPr>
          <a:xfrm>
            <a:off x="2449440" y="1544760"/>
            <a:ext cx="304920" cy="387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"/>
          <p:cNvSpPr/>
          <p:nvPr/>
        </p:nvSpPr>
        <p:spPr>
          <a:xfrm flipV="1">
            <a:off x="1063800" y="1889280"/>
            <a:ext cx="0" cy="10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"/>
          <p:cNvSpPr/>
          <p:nvPr/>
        </p:nvSpPr>
        <p:spPr>
          <a:xfrm>
            <a:off x="1049400" y="188928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"/>
          <p:cNvSpPr/>
          <p:nvPr/>
        </p:nvSpPr>
        <p:spPr>
          <a:xfrm flipV="1">
            <a:off x="1830240" y="1877760"/>
            <a:ext cx="0" cy="11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"/>
          <p:cNvSpPr/>
          <p:nvPr/>
        </p:nvSpPr>
        <p:spPr>
          <a:xfrm>
            <a:off x="1816200" y="187812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"/>
          <p:cNvSpPr/>
          <p:nvPr/>
        </p:nvSpPr>
        <p:spPr>
          <a:xfrm flipV="1">
            <a:off x="2602080" y="1376280"/>
            <a:ext cx="0" cy="168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"/>
          <p:cNvSpPr/>
          <p:nvPr/>
        </p:nvSpPr>
        <p:spPr>
          <a:xfrm>
            <a:off x="2587680" y="137628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"/>
          <p:cNvSpPr/>
          <p:nvPr/>
        </p:nvSpPr>
        <p:spPr>
          <a:xfrm>
            <a:off x="681120" y="1257480"/>
            <a:ext cx="0" cy="674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"/>
          <p:cNvSpPr/>
          <p:nvPr/>
        </p:nvSpPr>
        <p:spPr>
          <a:xfrm>
            <a:off x="681120" y="19321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"/>
          <p:cNvSpPr/>
          <p:nvPr/>
        </p:nvSpPr>
        <p:spPr>
          <a:xfrm>
            <a:off x="681120" y="18334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"/>
          <p:cNvSpPr/>
          <p:nvPr/>
        </p:nvSpPr>
        <p:spPr>
          <a:xfrm>
            <a:off x="681120" y="17413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"/>
          <p:cNvSpPr/>
          <p:nvPr/>
        </p:nvSpPr>
        <p:spPr>
          <a:xfrm>
            <a:off x="681120" y="16430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"/>
          <p:cNvSpPr/>
          <p:nvPr/>
        </p:nvSpPr>
        <p:spPr>
          <a:xfrm>
            <a:off x="681120" y="15447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"/>
          <p:cNvSpPr/>
          <p:nvPr/>
        </p:nvSpPr>
        <p:spPr>
          <a:xfrm>
            <a:off x="681120" y="14479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"/>
          <p:cNvSpPr/>
          <p:nvPr/>
        </p:nvSpPr>
        <p:spPr>
          <a:xfrm>
            <a:off x="681120" y="13539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"/>
          <p:cNvSpPr/>
          <p:nvPr/>
        </p:nvSpPr>
        <p:spPr>
          <a:xfrm>
            <a:off x="681120" y="12574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"/>
          <p:cNvSpPr/>
          <p:nvPr/>
        </p:nvSpPr>
        <p:spPr>
          <a:xfrm>
            <a:off x="681120" y="1932120"/>
            <a:ext cx="2306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"/>
          <p:cNvSpPr/>
          <p:nvPr/>
        </p:nvSpPr>
        <p:spPr>
          <a:xfrm flipV="1">
            <a:off x="681120" y="19098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"/>
          <p:cNvSpPr/>
          <p:nvPr/>
        </p:nvSpPr>
        <p:spPr>
          <a:xfrm flipV="1">
            <a:off x="1449360" y="19098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"/>
          <p:cNvSpPr/>
          <p:nvPr/>
        </p:nvSpPr>
        <p:spPr>
          <a:xfrm flipV="1">
            <a:off x="2220840" y="19098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"/>
          <p:cNvSpPr/>
          <p:nvPr/>
        </p:nvSpPr>
        <p:spPr>
          <a:xfrm flipV="1">
            <a:off x="2987640" y="19098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"/>
          <p:cNvSpPr/>
          <p:nvPr/>
        </p:nvSpPr>
        <p:spPr>
          <a:xfrm>
            <a:off x="1379520" y="117468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00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"/>
          <p:cNvSpPr/>
          <p:nvPr/>
        </p:nvSpPr>
        <p:spPr>
          <a:xfrm>
            <a:off x="468360" y="18813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"/>
          <p:cNvSpPr/>
          <p:nvPr/>
        </p:nvSpPr>
        <p:spPr>
          <a:xfrm>
            <a:off x="468360" y="18082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"/>
          <p:cNvSpPr/>
          <p:nvPr/>
        </p:nvSpPr>
        <p:spPr>
          <a:xfrm>
            <a:off x="468360" y="17002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"/>
          <p:cNvSpPr/>
          <p:nvPr/>
        </p:nvSpPr>
        <p:spPr>
          <a:xfrm>
            <a:off x="468360" y="15922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"/>
          <p:cNvSpPr/>
          <p:nvPr/>
        </p:nvSpPr>
        <p:spPr>
          <a:xfrm>
            <a:off x="468360" y="1521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"/>
          <p:cNvSpPr/>
          <p:nvPr/>
        </p:nvSpPr>
        <p:spPr>
          <a:xfrm>
            <a:off x="468360" y="1413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"/>
          <p:cNvSpPr/>
          <p:nvPr/>
        </p:nvSpPr>
        <p:spPr>
          <a:xfrm>
            <a:off x="468360" y="1305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"/>
          <p:cNvSpPr/>
          <p:nvPr/>
        </p:nvSpPr>
        <p:spPr>
          <a:xfrm>
            <a:off x="468360" y="1197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"/>
          <p:cNvSpPr/>
          <p:nvPr/>
        </p:nvSpPr>
        <p:spPr>
          <a:xfrm>
            <a:off x="1036800" y="19969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"/>
          <p:cNvSpPr/>
          <p:nvPr/>
        </p:nvSpPr>
        <p:spPr>
          <a:xfrm>
            <a:off x="1803240" y="19969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"/>
          <p:cNvSpPr/>
          <p:nvPr/>
        </p:nvSpPr>
        <p:spPr>
          <a:xfrm>
            <a:off x="2570040" y="19969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"/>
          <p:cNvSpPr/>
          <p:nvPr/>
        </p:nvSpPr>
        <p:spPr>
          <a:xfrm rot="16200000">
            <a:off x="-145440" y="137628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"/>
          <p:cNvSpPr/>
          <p:nvPr/>
        </p:nvSpPr>
        <p:spPr>
          <a:xfrm>
            <a:off x="3708360" y="1887480"/>
            <a:ext cx="314280" cy="288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"/>
          <p:cNvSpPr/>
          <p:nvPr/>
        </p:nvSpPr>
        <p:spPr>
          <a:xfrm>
            <a:off x="4483080" y="1863720"/>
            <a:ext cx="309600" cy="5256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"/>
          <p:cNvSpPr/>
          <p:nvPr/>
        </p:nvSpPr>
        <p:spPr>
          <a:xfrm>
            <a:off x="5253120" y="1601640"/>
            <a:ext cx="312480" cy="3146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"/>
          <p:cNvSpPr/>
          <p:nvPr/>
        </p:nvSpPr>
        <p:spPr>
          <a:xfrm flipV="1">
            <a:off x="3862440" y="1881000"/>
            <a:ext cx="0" cy="6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"/>
          <p:cNvSpPr/>
          <p:nvPr/>
        </p:nvSpPr>
        <p:spPr>
          <a:xfrm>
            <a:off x="3849840" y="1881360"/>
            <a:ext cx="298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"/>
          <p:cNvSpPr/>
          <p:nvPr/>
        </p:nvSpPr>
        <p:spPr>
          <a:xfrm flipV="1">
            <a:off x="4637160" y="1858680"/>
            <a:ext cx="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"/>
          <p:cNvSpPr/>
          <p:nvPr/>
        </p:nvSpPr>
        <p:spPr>
          <a:xfrm>
            <a:off x="4624560" y="1859040"/>
            <a:ext cx="298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"/>
          <p:cNvSpPr/>
          <p:nvPr/>
        </p:nvSpPr>
        <p:spPr>
          <a:xfrm flipV="1">
            <a:off x="5407200" y="1442520"/>
            <a:ext cx="0" cy="158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"/>
          <p:cNvSpPr/>
          <p:nvPr/>
        </p:nvSpPr>
        <p:spPr>
          <a:xfrm>
            <a:off x="5394240" y="14428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"/>
          <p:cNvSpPr/>
          <p:nvPr/>
        </p:nvSpPr>
        <p:spPr>
          <a:xfrm>
            <a:off x="3478320" y="1300320"/>
            <a:ext cx="0" cy="615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"/>
          <p:cNvSpPr/>
          <p:nvPr/>
        </p:nvSpPr>
        <p:spPr>
          <a:xfrm>
            <a:off x="3478320" y="191628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"/>
          <p:cNvSpPr/>
          <p:nvPr/>
        </p:nvSpPr>
        <p:spPr>
          <a:xfrm>
            <a:off x="3478320" y="179064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"/>
          <p:cNvSpPr/>
          <p:nvPr/>
        </p:nvSpPr>
        <p:spPr>
          <a:xfrm>
            <a:off x="3478320" y="167004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"/>
          <p:cNvSpPr/>
          <p:nvPr/>
        </p:nvSpPr>
        <p:spPr>
          <a:xfrm>
            <a:off x="3478320" y="154476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"/>
          <p:cNvSpPr/>
          <p:nvPr/>
        </p:nvSpPr>
        <p:spPr>
          <a:xfrm>
            <a:off x="3478320" y="142560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"/>
          <p:cNvSpPr/>
          <p:nvPr/>
        </p:nvSpPr>
        <p:spPr>
          <a:xfrm>
            <a:off x="3478320" y="130032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"/>
          <p:cNvSpPr/>
          <p:nvPr/>
        </p:nvSpPr>
        <p:spPr>
          <a:xfrm>
            <a:off x="3478320" y="1916280"/>
            <a:ext cx="2317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"/>
          <p:cNvSpPr/>
          <p:nvPr/>
        </p:nvSpPr>
        <p:spPr>
          <a:xfrm flipV="1">
            <a:off x="3478320" y="188748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"/>
          <p:cNvSpPr/>
          <p:nvPr/>
        </p:nvSpPr>
        <p:spPr>
          <a:xfrm flipV="1">
            <a:off x="4253040" y="188748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"/>
          <p:cNvSpPr/>
          <p:nvPr/>
        </p:nvSpPr>
        <p:spPr>
          <a:xfrm flipV="1">
            <a:off x="5022720" y="188748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"/>
          <p:cNvSpPr/>
          <p:nvPr/>
        </p:nvSpPr>
        <p:spPr>
          <a:xfrm flipV="1">
            <a:off x="5796000" y="188748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1" name=""/>
          <p:cNvSpPr/>
          <p:nvPr/>
        </p:nvSpPr>
        <p:spPr>
          <a:xfrm>
            <a:off x="4138560" y="108900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003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2" name=""/>
          <p:cNvSpPr/>
          <p:nvPr/>
        </p:nvSpPr>
        <p:spPr>
          <a:xfrm>
            <a:off x="3389400" y="1870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3" name=""/>
          <p:cNvSpPr/>
          <p:nvPr/>
        </p:nvSpPr>
        <p:spPr>
          <a:xfrm>
            <a:off x="3389400" y="17445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4" name=""/>
          <p:cNvSpPr/>
          <p:nvPr/>
        </p:nvSpPr>
        <p:spPr>
          <a:xfrm>
            <a:off x="3389400" y="1625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5" name=""/>
          <p:cNvSpPr/>
          <p:nvPr/>
        </p:nvSpPr>
        <p:spPr>
          <a:xfrm>
            <a:off x="3389400" y="15001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6" name=""/>
          <p:cNvSpPr/>
          <p:nvPr/>
        </p:nvSpPr>
        <p:spPr>
          <a:xfrm>
            <a:off x="3389400" y="1379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"/>
          <p:cNvSpPr/>
          <p:nvPr/>
        </p:nvSpPr>
        <p:spPr>
          <a:xfrm>
            <a:off x="3389400" y="1254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8" name=""/>
          <p:cNvSpPr/>
          <p:nvPr/>
        </p:nvSpPr>
        <p:spPr>
          <a:xfrm>
            <a:off x="3827520" y="19954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"/>
          <p:cNvSpPr/>
          <p:nvPr/>
        </p:nvSpPr>
        <p:spPr>
          <a:xfrm>
            <a:off x="4602240" y="19954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"/>
          <p:cNvSpPr/>
          <p:nvPr/>
        </p:nvSpPr>
        <p:spPr>
          <a:xfrm>
            <a:off x="5376960" y="19954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"/>
          <p:cNvSpPr/>
          <p:nvPr/>
        </p:nvSpPr>
        <p:spPr>
          <a:xfrm rot="16200000">
            <a:off x="2779920" y="141912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"/>
          <p:cNvSpPr/>
          <p:nvPr/>
        </p:nvSpPr>
        <p:spPr>
          <a:xfrm>
            <a:off x="6589800" y="1944720"/>
            <a:ext cx="325440" cy="396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3" name=""/>
          <p:cNvSpPr/>
          <p:nvPr/>
        </p:nvSpPr>
        <p:spPr>
          <a:xfrm>
            <a:off x="7408800" y="1913040"/>
            <a:ext cx="32544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"/>
          <p:cNvSpPr/>
          <p:nvPr/>
        </p:nvSpPr>
        <p:spPr>
          <a:xfrm>
            <a:off x="8228160" y="1666800"/>
            <a:ext cx="325440" cy="317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"/>
          <p:cNvSpPr/>
          <p:nvPr/>
        </p:nvSpPr>
        <p:spPr>
          <a:xfrm flipV="1">
            <a:off x="6753240" y="1925280"/>
            <a:ext cx="0" cy="19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"/>
          <p:cNvSpPr/>
          <p:nvPr/>
        </p:nvSpPr>
        <p:spPr>
          <a:xfrm>
            <a:off x="6737400" y="19256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"/>
          <p:cNvSpPr/>
          <p:nvPr/>
        </p:nvSpPr>
        <p:spPr>
          <a:xfrm flipV="1">
            <a:off x="7570800" y="1887120"/>
            <a:ext cx="0" cy="25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"/>
          <p:cNvSpPr/>
          <p:nvPr/>
        </p:nvSpPr>
        <p:spPr>
          <a:xfrm>
            <a:off x="7556400" y="188748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"/>
          <p:cNvSpPr/>
          <p:nvPr/>
        </p:nvSpPr>
        <p:spPr>
          <a:xfrm flipV="1">
            <a:off x="8389800" y="1441440"/>
            <a:ext cx="0" cy="225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0" name=""/>
          <p:cNvSpPr/>
          <p:nvPr/>
        </p:nvSpPr>
        <p:spPr>
          <a:xfrm>
            <a:off x="8375760" y="14414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1" name=""/>
          <p:cNvSpPr/>
          <p:nvPr/>
        </p:nvSpPr>
        <p:spPr>
          <a:xfrm>
            <a:off x="6343560" y="1312920"/>
            <a:ext cx="0" cy="671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2" name=""/>
          <p:cNvSpPr/>
          <p:nvPr/>
        </p:nvSpPr>
        <p:spPr>
          <a:xfrm>
            <a:off x="6343560" y="19843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"/>
          <p:cNvSpPr/>
          <p:nvPr/>
        </p:nvSpPr>
        <p:spPr>
          <a:xfrm>
            <a:off x="6343560" y="18748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4" name=""/>
          <p:cNvSpPr/>
          <p:nvPr/>
        </p:nvSpPr>
        <p:spPr>
          <a:xfrm>
            <a:off x="6343560" y="17575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5" name=""/>
          <p:cNvSpPr/>
          <p:nvPr/>
        </p:nvSpPr>
        <p:spPr>
          <a:xfrm>
            <a:off x="6343560" y="16477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6" name=""/>
          <p:cNvSpPr/>
          <p:nvPr/>
        </p:nvSpPr>
        <p:spPr>
          <a:xfrm>
            <a:off x="6343560" y="15382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7" name=""/>
          <p:cNvSpPr/>
          <p:nvPr/>
        </p:nvSpPr>
        <p:spPr>
          <a:xfrm>
            <a:off x="6343560" y="14223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8" name=""/>
          <p:cNvSpPr/>
          <p:nvPr/>
        </p:nvSpPr>
        <p:spPr>
          <a:xfrm>
            <a:off x="6343560" y="13129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9" name=""/>
          <p:cNvSpPr/>
          <p:nvPr/>
        </p:nvSpPr>
        <p:spPr>
          <a:xfrm>
            <a:off x="6343560" y="1984320"/>
            <a:ext cx="2455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0" name=""/>
          <p:cNvSpPr/>
          <p:nvPr/>
        </p:nvSpPr>
        <p:spPr>
          <a:xfrm flipV="1">
            <a:off x="6343560" y="19569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1" name=""/>
          <p:cNvSpPr/>
          <p:nvPr/>
        </p:nvSpPr>
        <p:spPr>
          <a:xfrm flipV="1">
            <a:off x="7161120" y="19569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"/>
          <p:cNvSpPr/>
          <p:nvPr/>
        </p:nvSpPr>
        <p:spPr>
          <a:xfrm flipV="1">
            <a:off x="7980480" y="19569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3" name=""/>
          <p:cNvSpPr/>
          <p:nvPr/>
        </p:nvSpPr>
        <p:spPr>
          <a:xfrm flipV="1">
            <a:off x="8799480" y="19569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4" name=""/>
          <p:cNvSpPr/>
          <p:nvPr/>
        </p:nvSpPr>
        <p:spPr>
          <a:xfrm>
            <a:off x="7135920" y="115740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00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5" name=""/>
          <p:cNvSpPr/>
          <p:nvPr/>
        </p:nvSpPr>
        <p:spPr>
          <a:xfrm>
            <a:off x="6120360" y="1952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6" name=""/>
          <p:cNvSpPr/>
          <p:nvPr/>
        </p:nvSpPr>
        <p:spPr>
          <a:xfrm>
            <a:off x="6120360" y="1808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7" name=""/>
          <p:cNvSpPr/>
          <p:nvPr/>
        </p:nvSpPr>
        <p:spPr>
          <a:xfrm>
            <a:off x="6120360" y="1700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"/>
          <p:cNvSpPr/>
          <p:nvPr/>
        </p:nvSpPr>
        <p:spPr>
          <a:xfrm>
            <a:off x="6120360" y="1592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9" name=""/>
          <p:cNvSpPr/>
          <p:nvPr/>
        </p:nvSpPr>
        <p:spPr>
          <a:xfrm>
            <a:off x="6120360" y="1484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0" name=""/>
          <p:cNvSpPr/>
          <p:nvPr/>
        </p:nvSpPr>
        <p:spPr>
          <a:xfrm>
            <a:off x="6120360" y="1376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1" name=""/>
          <p:cNvSpPr/>
          <p:nvPr/>
        </p:nvSpPr>
        <p:spPr>
          <a:xfrm>
            <a:off x="6120360" y="12682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2" name=""/>
          <p:cNvSpPr/>
          <p:nvPr/>
        </p:nvSpPr>
        <p:spPr>
          <a:xfrm>
            <a:off x="6718320" y="206064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3" name=""/>
          <p:cNvSpPr/>
          <p:nvPr/>
        </p:nvSpPr>
        <p:spPr>
          <a:xfrm>
            <a:off x="7537320" y="206064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4" name=""/>
          <p:cNvSpPr/>
          <p:nvPr/>
        </p:nvSpPr>
        <p:spPr>
          <a:xfrm>
            <a:off x="8356680" y="20606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5" name=""/>
          <p:cNvSpPr/>
          <p:nvPr/>
        </p:nvSpPr>
        <p:spPr>
          <a:xfrm rot="16200000">
            <a:off x="5472360" y="148428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6" name=""/>
          <p:cNvSpPr/>
          <p:nvPr/>
        </p:nvSpPr>
        <p:spPr>
          <a:xfrm>
            <a:off x="982800" y="3591000"/>
            <a:ext cx="307800" cy="65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7" name=""/>
          <p:cNvSpPr/>
          <p:nvPr/>
        </p:nvSpPr>
        <p:spPr>
          <a:xfrm>
            <a:off x="1749600" y="3595680"/>
            <a:ext cx="312480" cy="60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8" name=""/>
          <p:cNvSpPr/>
          <p:nvPr/>
        </p:nvSpPr>
        <p:spPr>
          <a:xfrm>
            <a:off x="2521080" y="3278160"/>
            <a:ext cx="307800" cy="378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9" name=""/>
          <p:cNvSpPr/>
          <p:nvPr/>
        </p:nvSpPr>
        <p:spPr>
          <a:xfrm flipV="1">
            <a:off x="1135080" y="3568680"/>
            <a:ext cx="0" cy="22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0" name=""/>
          <p:cNvSpPr/>
          <p:nvPr/>
        </p:nvSpPr>
        <p:spPr>
          <a:xfrm>
            <a:off x="1120680" y="356868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"/>
          <p:cNvSpPr/>
          <p:nvPr/>
        </p:nvSpPr>
        <p:spPr>
          <a:xfrm flipV="1">
            <a:off x="1906560" y="3568320"/>
            <a:ext cx="0" cy="27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2" name=""/>
          <p:cNvSpPr/>
          <p:nvPr/>
        </p:nvSpPr>
        <p:spPr>
          <a:xfrm>
            <a:off x="1892160" y="3568680"/>
            <a:ext cx="320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3" name=""/>
          <p:cNvSpPr/>
          <p:nvPr/>
        </p:nvSpPr>
        <p:spPr>
          <a:xfrm flipV="1">
            <a:off x="2673360" y="3079440"/>
            <a:ext cx="0" cy="198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4" name=""/>
          <p:cNvSpPr/>
          <p:nvPr/>
        </p:nvSpPr>
        <p:spPr>
          <a:xfrm>
            <a:off x="2658960" y="307980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5" name=""/>
          <p:cNvSpPr/>
          <p:nvPr/>
        </p:nvSpPr>
        <p:spPr>
          <a:xfrm>
            <a:off x="754200" y="2955960"/>
            <a:ext cx="0" cy="700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6" name=""/>
          <p:cNvSpPr/>
          <p:nvPr/>
        </p:nvSpPr>
        <p:spPr>
          <a:xfrm>
            <a:off x="754200" y="365616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7" name=""/>
          <p:cNvSpPr/>
          <p:nvPr/>
        </p:nvSpPr>
        <p:spPr>
          <a:xfrm>
            <a:off x="754200" y="355284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"/>
          <p:cNvSpPr/>
          <p:nvPr/>
        </p:nvSpPr>
        <p:spPr>
          <a:xfrm>
            <a:off x="754200" y="345600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"/>
          <p:cNvSpPr/>
          <p:nvPr/>
        </p:nvSpPr>
        <p:spPr>
          <a:xfrm>
            <a:off x="754200" y="335448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0" name=""/>
          <p:cNvSpPr/>
          <p:nvPr/>
        </p:nvSpPr>
        <p:spPr>
          <a:xfrm>
            <a:off x="754200" y="325764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1" name=""/>
          <p:cNvSpPr/>
          <p:nvPr/>
        </p:nvSpPr>
        <p:spPr>
          <a:xfrm>
            <a:off x="754200" y="315432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2" name=""/>
          <p:cNvSpPr/>
          <p:nvPr/>
        </p:nvSpPr>
        <p:spPr>
          <a:xfrm>
            <a:off x="754200" y="305748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3" name=""/>
          <p:cNvSpPr/>
          <p:nvPr/>
        </p:nvSpPr>
        <p:spPr>
          <a:xfrm>
            <a:off x="754200" y="295596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"/>
          <p:cNvSpPr/>
          <p:nvPr/>
        </p:nvSpPr>
        <p:spPr>
          <a:xfrm>
            <a:off x="754200" y="3656160"/>
            <a:ext cx="2305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"/>
          <p:cNvSpPr/>
          <p:nvPr/>
        </p:nvSpPr>
        <p:spPr>
          <a:xfrm flipV="1">
            <a:off x="754200" y="36338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"/>
          <p:cNvSpPr/>
          <p:nvPr/>
        </p:nvSpPr>
        <p:spPr>
          <a:xfrm flipV="1">
            <a:off x="1521000" y="36338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"/>
          <p:cNvSpPr/>
          <p:nvPr/>
        </p:nvSpPr>
        <p:spPr>
          <a:xfrm flipV="1">
            <a:off x="2292480" y="36338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"/>
          <p:cNvSpPr/>
          <p:nvPr/>
        </p:nvSpPr>
        <p:spPr>
          <a:xfrm flipV="1">
            <a:off x="3059280" y="363384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"/>
          <p:cNvSpPr/>
          <p:nvPr/>
        </p:nvSpPr>
        <p:spPr>
          <a:xfrm>
            <a:off x="1474920" y="285264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005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"/>
          <p:cNvSpPr/>
          <p:nvPr/>
        </p:nvSpPr>
        <p:spPr>
          <a:xfrm>
            <a:off x="469080" y="360828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1" name=""/>
          <p:cNvSpPr/>
          <p:nvPr/>
        </p:nvSpPr>
        <p:spPr>
          <a:xfrm>
            <a:off x="469080" y="350028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2" name=""/>
          <p:cNvSpPr/>
          <p:nvPr/>
        </p:nvSpPr>
        <p:spPr>
          <a:xfrm>
            <a:off x="469080" y="34290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3" name=""/>
          <p:cNvSpPr/>
          <p:nvPr/>
        </p:nvSpPr>
        <p:spPr>
          <a:xfrm>
            <a:off x="469080" y="33210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"/>
          <p:cNvSpPr/>
          <p:nvPr/>
        </p:nvSpPr>
        <p:spPr>
          <a:xfrm>
            <a:off x="469080" y="321300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"/>
          <p:cNvSpPr/>
          <p:nvPr/>
        </p:nvSpPr>
        <p:spPr>
          <a:xfrm>
            <a:off x="469080" y="314172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"/>
          <p:cNvSpPr/>
          <p:nvPr/>
        </p:nvSpPr>
        <p:spPr>
          <a:xfrm>
            <a:off x="469080" y="303372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"/>
          <p:cNvSpPr/>
          <p:nvPr/>
        </p:nvSpPr>
        <p:spPr>
          <a:xfrm>
            <a:off x="469080" y="2924280"/>
            <a:ext cx="220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Arial"/>
              </a:rPr>
              <a:t>0.0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"/>
          <p:cNvSpPr/>
          <p:nvPr/>
        </p:nvSpPr>
        <p:spPr>
          <a:xfrm>
            <a:off x="1106640" y="37195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"/>
          <p:cNvSpPr/>
          <p:nvPr/>
        </p:nvSpPr>
        <p:spPr>
          <a:xfrm>
            <a:off x="1873080" y="371952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0" name=""/>
          <p:cNvSpPr/>
          <p:nvPr/>
        </p:nvSpPr>
        <p:spPr>
          <a:xfrm>
            <a:off x="2641680" y="37195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1" name=""/>
          <p:cNvSpPr/>
          <p:nvPr/>
        </p:nvSpPr>
        <p:spPr>
          <a:xfrm rot="16200000">
            <a:off x="-231840" y="3154320"/>
            <a:ext cx="1160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2" name=""/>
          <p:cNvSpPr/>
          <p:nvPr/>
        </p:nvSpPr>
        <p:spPr>
          <a:xfrm>
            <a:off x="3797280" y="3571920"/>
            <a:ext cx="316080" cy="27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3" name=""/>
          <p:cNvSpPr/>
          <p:nvPr/>
        </p:nvSpPr>
        <p:spPr>
          <a:xfrm>
            <a:off x="4579920" y="3548160"/>
            <a:ext cx="311040" cy="50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4" name=""/>
          <p:cNvSpPr/>
          <p:nvPr/>
        </p:nvSpPr>
        <p:spPr>
          <a:xfrm>
            <a:off x="5356080" y="3151080"/>
            <a:ext cx="316080" cy="447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5" name=""/>
          <p:cNvSpPr/>
          <p:nvPr/>
        </p:nvSpPr>
        <p:spPr>
          <a:xfrm flipV="1">
            <a:off x="3952800" y="3561840"/>
            <a:ext cx="0" cy="9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6" name=""/>
          <p:cNvSpPr/>
          <p:nvPr/>
        </p:nvSpPr>
        <p:spPr>
          <a:xfrm>
            <a:off x="3940200" y="356220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7" name=""/>
          <p:cNvSpPr/>
          <p:nvPr/>
        </p:nvSpPr>
        <p:spPr>
          <a:xfrm flipV="1">
            <a:off x="4735440" y="3538080"/>
            <a:ext cx="0" cy="9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8" name=""/>
          <p:cNvSpPr/>
          <p:nvPr/>
        </p:nvSpPr>
        <p:spPr>
          <a:xfrm>
            <a:off x="4721400" y="353844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9" name=""/>
          <p:cNvSpPr/>
          <p:nvPr/>
        </p:nvSpPr>
        <p:spPr>
          <a:xfrm flipV="1">
            <a:off x="5511960" y="2943000"/>
            <a:ext cx="0" cy="207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0" name=""/>
          <p:cNvSpPr/>
          <p:nvPr/>
        </p:nvSpPr>
        <p:spPr>
          <a:xfrm>
            <a:off x="5499000" y="294336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1" name=""/>
          <p:cNvSpPr/>
          <p:nvPr/>
        </p:nvSpPr>
        <p:spPr>
          <a:xfrm>
            <a:off x="3565440" y="2884320"/>
            <a:ext cx="0" cy="714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2" name=""/>
          <p:cNvSpPr/>
          <p:nvPr/>
        </p:nvSpPr>
        <p:spPr>
          <a:xfrm>
            <a:off x="3565440" y="359892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3" name=""/>
          <p:cNvSpPr/>
          <p:nvPr/>
        </p:nvSpPr>
        <p:spPr>
          <a:xfrm>
            <a:off x="3565440" y="34974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4" name=""/>
          <p:cNvSpPr/>
          <p:nvPr/>
        </p:nvSpPr>
        <p:spPr>
          <a:xfrm>
            <a:off x="3565440" y="339552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5" name=""/>
          <p:cNvSpPr/>
          <p:nvPr/>
        </p:nvSpPr>
        <p:spPr>
          <a:xfrm>
            <a:off x="3565440" y="32940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6" name=""/>
          <p:cNvSpPr/>
          <p:nvPr/>
        </p:nvSpPr>
        <p:spPr>
          <a:xfrm>
            <a:off x="3565440" y="31878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7" name=""/>
          <p:cNvSpPr/>
          <p:nvPr/>
        </p:nvSpPr>
        <p:spPr>
          <a:xfrm>
            <a:off x="3565440" y="308628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8" name=""/>
          <p:cNvSpPr/>
          <p:nvPr/>
        </p:nvSpPr>
        <p:spPr>
          <a:xfrm>
            <a:off x="3565440" y="298620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9" name=""/>
          <p:cNvSpPr/>
          <p:nvPr/>
        </p:nvSpPr>
        <p:spPr>
          <a:xfrm>
            <a:off x="3565440" y="2884320"/>
            <a:ext cx="22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0" name=""/>
          <p:cNvSpPr/>
          <p:nvPr/>
        </p:nvSpPr>
        <p:spPr>
          <a:xfrm>
            <a:off x="3565440" y="3598920"/>
            <a:ext cx="2340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1" name=""/>
          <p:cNvSpPr/>
          <p:nvPr/>
        </p:nvSpPr>
        <p:spPr>
          <a:xfrm flipV="1">
            <a:off x="3565440" y="35766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"/>
          <p:cNvSpPr/>
          <p:nvPr/>
        </p:nvSpPr>
        <p:spPr>
          <a:xfrm flipV="1">
            <a:off x="4346640" y="35766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3" name=""/>
          <p:cNvSpPr/>
          <p:nvPr/>
        </p:nvSpPr>
        <p:spPr>
          <a:xfrm flipV="1">
            <a:off x="5124600" y="35766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4" name=""/>
          <p:cNvSpPr/>
          <p:nvPr/>
        </p:nvSpPr>
        <p:spPr>
          <a:xfrm flipV="1">
            <a:off x="5905440" y="3576600"/>
            <a:ext cx="0" cy="22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5" name=""/>
          <p:cNvSpPr/>
          <p:nvPr/>
        </p:nvSpPr>
        <p:spPr>
          <a:xfrm>
            <a:off x="4257720" y="280512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002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6" name=""/>
          <p:cNvSpPr/>
          <p:nvPr/>
        </p:nvSpPr>
        <p:spPr>
          <a:xfrm>
            <a:off x="3390840" y="35575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7" name=""/>
          <p:cNvSpPr/>
          <p:nvPr/>
        </p:nvSpPr>
        <p:spPr>
          <a:xfrm>
            <a:off x="3390840" y="3456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8" name=""/>
          <p:cNvSpPr/>
          <p:nvPr/>
        </p:nvSpPr>
        <p:spPr>
          <a:xfrm>
            <a:off x="3390840" y="33544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9" name=""/>
          <p:cNvSpPr/>
          <p:nvPr/>
        </p:nvSpPr>
        <p:spPr>
          <a:xfrm>
            <a:off x="3390840" y="32529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0" name=""/>
          <p:cNvSpPr/>
          <p:nvPr/>
        </p:nvSpPr>
        <p:spPr>
          <a:xfrm>
            <a:off x="3390840" y="31464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1" name=""/>
          <p:cNvSpPr/>
          <p:nvPr/>
        </p:nvSpPr>
        <p:spPr>
          <a:xfrm>
            <a:off x="3390840" y="30448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"/>
          <p:cNvSpPr/>
          <p:nvPr/>
        </p:nvSpPr>
        <p:spPr>
          <a:xfrm>
            <a:off x="3390840" y="29433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"/>
          <p:cNvSpPr/>
          <p:nvPr/>
        </p:nvSpPr>
        <p:spPr>
          <a:xfrm>
            <a:off x="3390840" y="28414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"/>
          <p:cNvSpPr/>
          <p:nvPr/>
        </p:nvSpPr>
        <p:spPr>
          <a:xfrm>
            <a:off x="3911760" y="36687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"/>
          <p:cNvSpPr/>
          <p:nvPr/>
        </p:nvSpPr>
        <p:spPr>
          <a:xfrm>
            <a:off x="4694400" y="366876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"/>
          <p:cNvSpPr/>
          <p:nvPr/>
        </p:nvSpPr>
        <p:spPr>
          <a:xfrm>
            <a:off x="5475240" y="36687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"/>
          <p:cNvSpPr/>
          <p:nvPr/>
        </p:nvSpPr>
        <p:spPr>
          <a:xfrm rot="16200000">
            <a:off x="2698920" y="306828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"/>
          <p:cNvSpPr/>
          <p:nvPr/>
        </p:nvSpPr>
        <p:spPr>
          <a:xfrm>
            <a:off x="8186760" y="3200400"/>
            <a:ext cx="324000" cy="422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"/>
          <p:cNvSpPr/>
          <p:nvPr/>
        </p:nvSpPr>
        <p:spPr>
          <a:xfrm>
            <a:off x="6737400" y="3622680"/>
            <a:ext cx="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0" name=""/>
          <p:cNvSpPr/>
          <p:nvPr/>
        </p:nvSpPr>
        <p:spPr>
          <a:xfrm>
            <a:off x="6723000" y="362268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1" name=""/>
          <p:cNvSpPr/>
          <p:nvPr/>
        </p:nvSpPr>
        <p:spPr>
          <a:xfrm flipV="1">
            <a:off x="7540560" y="3617640"/>
            <a:ext cx="0" cy="4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2" name=""/>
          <p:cNvSpPr/>
          <p:nvPr/>
        </p:nvSpPr>
        <p:spPr>
          <a:xfrm>
            <a:off x="7526160" y="36180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"/>
          <p:cNvSpPr/>
          <p:nvPr/>
        </p:nvSpPr>
        <p:spPr>
          <a:xfrm flipV="1">
            <a:off x="8348760" y="3059280"/>
            <a:ext cx="0" cy="141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"/>
          <p:cNvSpPr/>
          <p:nvPr/>
        </p:nvSpPr>
        <p:spPr>
          <a:xfrm>
            <a:off x="8334360" y="305928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"/>
          <p:cNvSpPr/>
          <p:nvPr/>
        </p:nvSpPr>
        <p:spPr>
          <a:xfrm>
            <a:off x="6334200" y="2975040"/>
            <a:ext cx="0" cy="64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6" name=""/>
          <p:cNvSpPr/>
          <p:nvPr/>
        </p:nvSpPr>
        <p:spPr>
          <a:xfrm>
            <a:off x="6334200" y="36226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7" name=""/>
          <p:cNvSpPr/>
          <p:nvPr/>
        </p:nvSpPr>
        <p:spPr>
          <a:xfrm>
            <a:off x="6334200" y="34941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"/>
          <p:cNvSpPr/>
          <p:nvPr/>
        </p:nvSpPr>
        <p:spPr>
          <a:xfrm>
            <a:off x="6334200" y="336384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"/>
          <p:cNvSpPr/>
          <p:nvPr/>
        </p:nvSpPr>
        <p:spPr>
          <a:xfrm>
            <a:off x="6334200" y="32338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0" name=""/>
          <p:cNvSpPr/>
          <p:nvPr/>
        </p:nvSpPr>
        <p:spPr>
          <a:xfrm>
            <a:off x="6334200" y="31050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1" name=""/>
          <p:cNvSpPr/>
          <p:nvPr/>
        </p:nvSpPr>
        <p:spPr>
          <a:xfrm>
            <a:off x="6334200" y="297504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"/>
          <p:cNvSpPr/>
          <p:nvPr/>
        </p:nvSpPr>
        <p:spPr>
          <a:xfrm>
            <a:off x="6334200" y="3622680"/>
            <a:ext cx="2415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"/>
          <p:cNvSpPr/>
          <p:nvPr/>
        </p:nvSpPr>
        <p:spPr>
          <a:xfrm flipV="1">
            <a:off x="6334200" y="359532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4" name=""/>
          <p:cNvSpPr/>
          <p:nvPr/>
        </p:nvSpPr>
        <p:spPr>
          <a:xfrm flipV="1">
            <a:off x="7139160" y="359532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"/>
          <p:cNvSpPr/>
          <p:nvPr/>
        </p:nvSpPr>
        <p:spPr>
          <a:xfrm flipV="1">
            <a:off x="7947000" y="359532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"/>
          <p:cNvSpPr/>
          <p:nvPr/>
        </p:nvSpPr>
        <p:spPr>
          <a:xfrm flipV="1">
            <a:off x="8750160" y="359532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"/>
          <p:cNvSpPr/>
          <p:nvPr/>
        </p:nvSpPr>
        <p:spPr>
          <a:xfrm>
            <a:off x="6983280" y="285264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475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"/>
          <p:cNvSpPr/>
          <p:nvPr/>
        </p:nvSpPr>
        <p:spPr>
          <a:xfrm>
            <a:off x="6242040" y="3578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"/>
          <p:cNvSpPr/>
          <p:nvPr/>
        </p:nvSpPr>
        <p:spPr>
          <a:xfrm>
            <a:off x="6242040" y="3448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"/>
          <p:cNvSpPr/>
          <p:nvPr/>
        </p:nvSpPr>
        <p:spPr>
          <a:xfrm>
            <a:off x="6242040" y="33195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"/>
          <p:cNvSpPr/>
          <p:nvPr/>
        </p:nvSpPr>
        <p:spPr>
          <a:xfrm>
            <a:off x="6242040" y="3189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"/>
          <p:cNvSpPr/>
          <p:nvPr/>
        </p:nvSpPr>
        <p:spPr>
          <a:xfrm>
            <a:off x="6242040" y="3059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"/>
          <p:cNvSpPr/>
          <p:nvPr/>
        </p:nvSpPr>
        <p:spPr>
          <a:xfrm>
            <a:off x="6206040" y="2930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"/>
          <p:cNvSpPr/>
          <p:nvPr/>
        </p:nvSpPr>
        <p:spPr>
          <a:xfrm>
            <a:off x="6699240" y="37018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"/>
          <p:cNvSpPr/>
          <p:nvPr/>
        </p:nvSpPr>
        <p:spPr>
          <a:xfrm>
            <a:off x="7508880" y="37018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"/>
          <p:cNvSpPr/>
          <p:nvPr/>
        </p:nvSpPr>
        <p:spPr>
          <a:xfrm>
            <a:off x="8312040" y="37018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"/>
          <p:cNvSpPr/>
          <p:nvPr/>
        </p:nvSpPr>
        <p:spPr>
          <a:xfrm rot="16200000">
            <a:off x="5589720" y="310176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8" name=""/>
          <p:cNvSpPr/>
          <p:nvPr/>
        </p:nvSpPr>
        <p:spPr>
          <a:xfrm>
            <a:off x="928800" y="5430960"/>
            <a:ext cx="307800" cy="29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9" name=""/>
          <p:cNvSpPr/>
          <p:nvPr/>
        </p:nvSpPr>
        <p:spPr>
          <a:xfrm>
            <a:off x="1703520" y="5376960"/>
            <a:ext cx="312480" cy="83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0" name=""/>
          <p:cNvSpPr/>
          <p:nvPr/>
        </p:nvSpPr>
        <p:spPr>
          <a:xfrm>
            <a:off x="2482920" y="5025960"/>
            <a:ext cx="307800" cy="434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1" name=""/>
          <p:cNvSpPr/>
          <p:nvPr/>
        </p:nvSpPr>
        <p:spPr>
          <a:xfrm flipV="1">
            <a:off x="1082520" y="5420880"/>
            <a:ext cx="0" cy="9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2" name=""/>
          <p:cNvSpPr/>
          <p:nvPr/>
        </p:nvSpPr>
        <p:spPr>
          <a:xfrm>
            <a:off x="1069920" y="542124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3" name=""/>
          <p:cNvSpPr/>
          <p:nvPr/>
        </p:nvSpPr>
        <p:spPr>
          <a:xfrm flipV="1">
            <a:off x="1857240" y="5341680"/>
            <a:ext cx="0" cy="34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4" name=""/>
          <p:cNvSpPr/>
          <p:nvPr/>
        </p:nvSpPr>
        <p:spPr>
          <a:xfrm>
            <a:off x="1844640" y="534204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5" name=""/>
          <p:cNvSpPr/>
          <p:nvPr/>
        </p:nvSpPr>
        <p:spPr>
          <a:xfrm flipV="1">
            <a:off x="2637000" y="4828680"/>
            <a:ext cx="0" cy="196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6" name=""/>
          <p:cNvSpPr/>
          <p:nvPr/>
        </p:nvSpPr>
        <p:spPr>
          <a:xfrm>
            <a:off x="2622600" y="482904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7" name=""/>
          <p:cNvSpPr/>
          <p:nvPr/>
        </p:nvSpPr>
        <p:spPr>
          <a:xfrm>
            <a:off x="698400" y="4794120"/>
            <a:ext cx="0" cy="66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8" name=""/>
          <p:cNvSpPr/>
          <p:nvPr/>
        </p:nvSpPr>
        <p:spPr>
          <a:xfrm>
            <a:off x="698400" y="546084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9" name=""/>
          <p:cNvSpPr/>
          <p:nvPr/>
        </p:nvSpPr>
        <p:spPr>
          <a:xfrm>
            <a:off x="698400" y="534672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0" name=""/>
          <p:cNvSpPr/>
          <p:nvPr/>
        </p:nvSpPr>
        <p:spPr>
          <a:xfrm>
            <a:off x="698400" y="523872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"/>
          <p:cNvSpPr/>
          <p:nvPr/>
        </p:nvSpPr>
        <p:spPr>
          <a:xfrm>
            <a:off x="698400" y="512604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2" name=""/>
          <p:cNvSpPr/>
          <p:nvPr/>
        </p:nvSpPr>
        <p:spPr>
          <a:xfrm>
            <a:off x="698400" y="501660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3" name=""/>
          <p:cNvSpPr/>
          <p:nvPr/>
        </p:nvSpPr>
        <p:spPr>
          <a:xfrm>
            <a:off x="698400" y="490392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"/>
          <p:cNvSpPr/>
          <p:nvPr/>
        </p:nvSpPr>
        <p:spPr>
          <a:xfrm>
            <a:off x="698400" y="479412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"/>
          <p:cNvSpPr/>
          <p:nvPr/>
        </p:nvSpPr>
        <p:spPr>
          <a:xfrm>
            <a:off x="698400" y="5460840"/>
            <a:ext cx="2327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"/>
          <p:cNvSpPr/>
          <p:nvPr/>
        </p:nvSpPr>
        <p:spPr>
          <a:xfrm flipV="1">
            <a:off x="698400" y="5439960"/>
            <a:ext cx="0" cy="20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"/>
          <p:cNvSpPr/>
          <p:nvPr/>
        </p:nvSpPr>
        <p:spPr>
          <a:xfrm flipV="1">
            <a:off x="1473120" y="5439960"/>
            <a:ext cx="0" cy="20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"/>
          <p:cNvSpPr/>
          <p:nvPr/>
        </p:nvSpPr>
        <p:spPr>
          <a:xfrm flipV="1">
            <a:off x="2251080" y="5439960"/>
            <a:ext cx="0" cy="20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"/>
          <p:cNvSpPr/>
          <p:nvPr/>
        </p:nvSpPr>
        <p:spPr>
          <a:xfrm flipV="1">
            <a:off x="3025800" y="5439960"/>
            <a:ext cx="0" cy="20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"/>
          <p:cNvSpPr/>
          <p:nvPr/>
        </p:nvSpPr>
        <p:spPr>
          <a:xfrm>
            <a:off x="1386000" y="4749840"/>
            <a:ext cx="625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000000"/>
                </a:solidFill>
                <a:latin typeface="Arial"/>
              </a:rPr>
              <a:t>PXO_047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"/>
          <p:cNvSpPr/>
          <p:nvPr/>
        </p:nvSpPr>
        <p:spPr>
          <a:xfrm>
            <a:off x="468720" y="5408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"/>
          <p:cNvSpPr/>
          <p:nvPr/>
        </p:nvSpPr>
        <p:spPr>
          <a:xfrm>
            <a:off x="468720" y="5300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"/>
          <p:cNvSpPr/>
          <p:nvPr/>
        </p:nvSpPr>
        <p:spPr>
          <a:xfrm>
            <a:off x="468720" y="5192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"/>
          <p:cNvSpPr/>
          <p:nvPr/>
        </p:nvSpPr>
        <p:spPr>
          <a:xfrm>
            <a:off x="468720" y="5084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"/>
          <p:cNvSpPr/>
          <p:nvPr/>
        </p:nvSpPr>
        <p:spPr>
          <a:xfrm>
            <a:off x="468720" y="49766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"/>
          <p:cNvSpPr/>
          <p:nvPr/>
        </p:nvSpPr>
        <p:spPr>
          <a:xfrm>
            <a:off x="468720" y="486900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7" name=""/>
          <p:cNvSpPr/>
          <p:nvPr/>
        </p:nvSpPr>
        <p:spPr>
          <a:xfrm>
            <a:off x="468720" y="476100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0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8" name=""/>
          <p:cNvSpPr/>
          <p:nvPr/>
        </p:nvSpPr>
        <p:spPr>
          <a:xfrm>
            <a:off x="1050840" y="55198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9" name=""/>
          <p:cNvSpPr/>
          <p:nvPr/>
        </p:nvSpPr>
        <p:spPr>
          <a:xfrm>
            <a:off x="1825560" y="5519880"/>
            <a:ext cx="12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P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"/>
          <p:cNvSpPr/>
          <p:nvPr/>
        </p:nvSpPr>
        <p:spPr>
          <a:xfrm>
            <a:off x="2600280" y="55198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"/>
          <p:cNvSpPr/>
          <p:nvPr/>
        </p:nvSpPr>
        <p:spPr>
          <a:xfrm rot="16200000">
            <a:off x="-180360" y="4939920"/>
            <a:ext cx="1131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Relative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"/>
          <p:cNvSpPr/>
          <p:nvPr/>
        </p:nvSpPr>
        <p:spPr>
          <a:xfrm>
            <a:off x="1494000" y="2097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"/>
          <p:cNvSpPr/>
          <p:nvPr/>
        </p:nvSpPr>
        <p:spPr>
          <a:xfrm>
            <a:off x="4394160" y="2097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"/>
          <p:cNvSpPr/>
          <p:nvPr/>
        </p:nvSpPr>
        <p:spPr>
          <a:xfrm>
            <a:off x="7381800" y="216864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5" name=""/>
          <p:cNvSpPr/>
          <p:nvPr/>
        </p:nvSpPr>
        <p:spPr>
          <a:xfrm>
            <a:off x="1477800" y="382428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6" name=""/>
          <p:cNvSpPr/>
          <p:nvPr/>
        </p:nvSpPr>
        <p:spPr>
          <a:xfrm>
            <a:off x="4465800" y="382428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7" name=""/>
          <p:cNvSpPr/>
          <p:nvPr/>
        </p:nvSpPr>
        <p:spPr>
          <a:xfrm>
            <a:off x="7418520" y="386064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8" name=""/>
          <p:cNvSpPr/>
          <p:nvPr/>
        </p:nvSpPr>
        <p:spPr>
          <a:xfrm>
            <a:off x="1477800" y="5661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Arial"/>
              </a:rPr>
              <a:t>Str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番茄花园</cp:lastModifiedBy>
  <dcterms:modified xsi:type="dcterms:W3CDTF">2013-02-07T09:25:18Z</dcterms:modified>
  <cp:revision>6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